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23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dell%20pc\Dropbox\Prove%20Magnololo%20e%20sinergici\Final%20histogram%20_magn%20paper\Magnolo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0189554502662583E-2"/>
          <c:y val="1.6212367859124232E-2"/>
          <c:w val="0.88710972902410434"/>
          <c:h val="0.816838046361156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graph%'!$C$38</c:f>
              <c:strCache>
                <c:ptCount val="1"/>
                <c:pt idx="0">
                  <c:v>400 µg/ml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raph%'!$D$39:$D$53</c:f>
                <c:numCache>
                  <c:formatCode>General</c:formatCode>
                  <c:ptCount val="15"/>
                  <c:pt idx="0">
                    <c:v>2.3094010767585029</c:v>
                  </c:pt>
                  <c:pt idx="1">
                    <c:v>2.4135250625797595</c:v>
                  </c:pt>
                  <c:pt idx="2">
                    <c:v>0.41239304942116184</c:v>
                  </c:pt>
                  <c:pt idx="3">
                    <c:v>2.4056261216234391</c:v>
                  </c:pt>
                  <c:pt idx="4">
                    <c:v>2.9937974107073271</c:v>
                  </c:pt>
                  <c:pt idx="5">
                    <c:v>2.8195612304653204</c:v>
                  </c:pt>
                  <c:pt idx="6">
                    <c:v>0.85322699880240449</c:v>
                  </c:pt>
                  <c:pt idx="7">
                    <c:v>2.3094010767585029</c:v>
                  </c:pt>
                  <c:pt idx="8">
                    <c:v>0.46453469934797509</c:v>
                  </c:pt>
                  <c:pt idx="9">
                    <c:v>2.0176733920929233</c:v>
                  </c:pt>
                  <c:pt idx="10">
                    <c:v>2.612449136463233</c:v>
                  </c:pt>
                  <c:pt idx="11">
                    <c:v>1.3272419981370718</c:v>
                  </c:pt>
                  <c:pt idx="12">
                    <c:v>0.34920379184856432</c:v>
                  </c:pt>
                  <c:pt idx="13">
                    <c:v>0.46453469934797509</c:v>
                  </c:pt>
                  <c:pt idx="14">
                    <c:v>0.67357531405456406</c:v>
                  </c:pt>
                </c:numCache>
              </c:numRef>
            </c:plus>
            <c:minus>
              <c:numRef>
                <c:f>'graph%'!$D$39:$D$53</c:f>
                <c:numCache>
                  <c:formatCode>General</c:formatCode>
                  <c:ptCount val="15"/>
                  <c:pt idx="0">
                    <c:v>2.3094010767585029</c:v>
                  </c:pt>
                  <c:pt idx="1">
                    <c:v>2.4135250625797595</c:v>
                  </c:pt>
                  <c:pt idx="2">
                    <c:v>0.41239304942116184</c:v>
                  </c:pt>
                  <c:pt idx="3">
                    <c:v>2.4056261216234391</c:v>
                  </c:pt>
                  <c:pt idx="4">
                    <c:v>2.9937974107073271</c:v>
                  </c:pt>
                  <c:pt idx="5">
                    <c:v>2.8195612304653204</c:v>
                  </c:pt>
                  <c:pt idx="6">
                    <c:v>0.85322699880240449</c:v>
                  </c:pt>
                  <c:pt idx="7">
                    <c:v>2.3094010767585029</c:v>
                  </c:pt>
                  <c:pt idx="8">
                    <c:v>0.46453469934797509</c:v>
                  </c:pt>
                  <c:pt idx="9">
                    <c:v>2.0176733920929233</c:v>
                  </c:pt>
                  <c:pt idx="10">
                    <c:v>2.612449136463233</c:v>
                  </c:pt>
                  <c:pt idx="11">
                    <c:v>1.3272419981370718</c:v>
                  </c:pt>
                  <c:pt idx="12">
                    <c:v>0.34920379184856432</c:v>
                  </c:pt>
                  <c:pt idx="13">
                    <c:v>0.46453469934797509</c:v>
                  </c:pt>
                  <c:pt idx="14">
                    <c:v>0.67357531405456406</c:v>
                  </c:pt>
                </c:numCache>
              </c:numRef>
            </c:minus>
          </c:errBars>
          <c:cat>
            <c:strRef>
              <c:f>'graph%'!$B$39:$B$53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'graph%'!$C$39:$C$53</c:f>
              <c:numCache>
                <c:formatCode>0.00</c:formatCode>
                <c:ptCount val="15"/>
                <c:pt idx="0">
                  <c:v>38.666666666666664</c:v>
                </c:pt>
                <c:pt idx="1">
                  <c:v>19.985569985569985</c:v>
                </c:pt>
                <c:pt idx="2">
                  <c:v>14.761904761904761</c:v>
                </c:pt>
                <c:pt idx="3">
                  <c:v>22.222222222222225</c:v>
                </c:pt>
                <c:pt idx="4">
                  <c:v>18.376811594202902</c:v>
                </c:pt>
                <c:pt idx="5">
                  <c:v>23.80952380952381</c:v>
                </c:pt>
                <c:pt idx="6">
                  <c:v>41.871921182266014</c:v>
                </c:pt>
                <c:pt idx="7">
                  <c:v>34.666666666666664</c:v>
                </c:pt>
                <c:pt idx="8">
                  <c:v>23.869731800766285</c:v>
                </c:pt>
                <c:pt idx="9">
                  <c:v>38.153846153846153</c:v>
                </c:pt>
                <c:pt idx="10">
                  <c:v>31.671415004748336</c:v>
                </c:pt>
                <c:pt idx="11">
                  <c:v>31.800766283524904</c:v>
                </c:pt>
                <c:pt idx="12">
                  <c:v>19.153225806451616</c:v>
                </c:pt>
                <c:pt idx="13">
                  <c:v>23.601532567049805</c:v>
                </c:pt>
                <c:pt idx="14">
                  <c:v>28.3888888888888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6CE-485B-9E4B-082D1D452CA0}"/>
            </c:ext>
          </c:extLst>
        </c:ser>
        <c:ser>
          <c:idx val="3"/>
          <c:order val="1"/>
          <c:tx>
            <c:strRef>
              <c:f>'graph%'!$E$38</c:f>
              <c:strCache>
                <c:ptCount val="1"/>
                <c:pt idx="0">
                  <c:v>200 µg/ml</c:v>
                </c:pt>
              </c:strCache>
            </c:strRef>
          </c:tx>
          <c:spPr>
            <a:solidFill>
              <a:schemeClr val="tx2">
                <a:lumMod val="40000"/>
                <a:lumOff val="6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raph%'!$F$39:$F$53</c:f>
                <c:numCache>
                  <c:formatCode>General</c:formatCode>
                  <c:ptCount val="15"/>
                  <c:pt idx="0">
                    <c:v>5.0942670810849311</c:v>
                  </c:pt>
                  <c:pt idx="1">
                    <c:v>0.66362099906853589</c:v>
                  </c:pt>
                  <c:pt idx="2">
                    <c:v>2.3026788047994966</c:v>
                  </c:pt>
                  <c:pt idx="3">
                    <c:v>0.90467990898659667</c:v>
                  </c:pt>
                  <c:pt idx="4">
                    <c:v>0.69840758369712863</c:v>
                  </c:pt>
                  <c:pt idx="5">
                    <c:v>1.6037507477489565</c:v>
                  </c:pt>
                  <c:pt idx="6">
                    <c:v>0.93121011159617284</c:v>
                  </c:pt>
                  <c:pt idx="7">
                    <c:v>2.061965247105805</c:v>
                  </c:pt>
                  <c:pt idx="8">
                    <c:v>0.43344614804026149</c:v>
                  </c:pt>
                  <c:pt idx="9">
                    <c:v>0</c:v>
                  </c:pt>
                  <c:pt idx="10">
                    <c:v>1.0699927768765285</c:v>
                  </c:pt>
                  <c:pt idx="11">
                    <c:v>1.6037507477489608</c:v>
                  </c:pt>
                  <c:pt idx="12">
                    <c:v>1.4683857055553138</c:v>
                  </c:pt>
                  <c:pt idx="13">
                    <c:v>1.2129207335916505</c:v>
                  </c:pt>
                  <c:pt idx="14">
                    <c:v>1.9382458142303864</c:v>
                  </c:pt>
                </c:numCache>
              </c:numRef>
            </c:plus>
            <c:minus>
              <c:numRef>
                <c:f>'graph%'!$F$39:$F$53</c:f>
                <c:numCache>
                  <c:formatCode>General</c:formatCode>
                  <c:ptCount val="15"/>
                  <c:pt idx="0">
                    <c:v>5.0942670810849311</c:v>
                  </c:pt>
                  <c:pt idx="1">
                    <c:v>0.66362099906853589</c:v>
                  </c:pt>
                  <c:pt idx="2">
                    <c:v>2.3026788047994966</c:v>
                  </c:pt>
                  <c:pt idx="3">
                    <c:v>0.90467990898659667</c:v>
                  </c:pt>
                  <c:pt idx="4">
                    <c:v>0.69840758369712863</c:v>
                  </c:pt>
                  <c:pt idx="5">
                    <c:v>1.6037507477489565</c:v>
                  </c:pt>
                  <c:pt idx="6">
                    <c:v>0.93121011159617284</c:v>
                  </c:pt>
                  <c:pt idx="7">
                    <c:v>2.061965247105805</c:v>
                  </c:pt>
                  <c:pt idx="8">
                    <c:v>0.43344614804026149</c:v>
                  </c:pt>
                  <c:pt idx="9">
                    <c:v>0</c:v>
                  </c:pt>
                  <c:pt idx="10">
                    <c:v>1.0699927768765285</c:v>
                  </c:pt>
                  <c:pt idx="11">
                    <c:v>1.6037507477489608</c:v>
                  </c:pt>
                  <c:pt idx="12">
                    <c:v>1.4683857055553138</c:v>
                  </c:pt>
                  <c:pt idx="13">
                    <c:v>1.2129207335916505</c:v>
                  </c:pt>
                  <c:pt idx="14">
                    <c:v>1.9382458142303864</c:v>
                  </c:pt>
                </c:numCache>
              </c:numRef>
            </c:minus>
          </c:errBars>
          <c:cat>
            <c:strRef>
              <c:f>'graph%'!$B$39:$B$53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'graph%'!$E$39:$E$53</c:f>
              <c:numCache>
                <c:formatCode>0.00</c:formatCode>
                <c:ptCount val="15"/>
                <c:pt idx="0">
                  <c:v>44.117647058823536</c:v>
                </c:pt>
                <c:pt idx="1">
                  <c:v>34.099616858237546</c:v>
                </c:pt>
                <c:pt idx="2">
                  <c:v>28.42911877394636</c:v>
                </c:pt>
                <c:pt idx="3">
                  <c:v>41.785375118708458</c:v>
                </c:pt>
                <c:pt idx="4">
                  <c:v>38.306451612903231</c:v>
                </c:pt>
                <c:pt idx="5">
                  <c:v>34.25925925925926</c:v>
                </c:pt>
                <c:pt idx="6">
                  <c:v>48.924731182795689</c:v>
                </c:pt>
                <c:pt idx="7">
                  <c:v>47.61904761904762</c:v>
                </c:pt>
                <c:pt idx="8">
                  <c:v>27.527527527527525</c:v>
                </c:pt>
                <c:pt idx="9">
                  <c:v>50</c:v>
                </c:pt>
                <c:pt idx="10">
                  <c:v>33.667953667953668</c:v>
                </c:pt>
                <c:pt idx="11">
                  <c:v>37.962962962962962</c:v>
                </c:pt>
                <c:pt idx="12">
                  <c:v>29.803921568627455</c:v>
                </c:pt>
                <c:pt idx="13">
                  <c:v>27.170868347338939</c:v>
                </c:pt>
                <c:pt idx="14">
                  <c:v>27.899159663865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6CE-485B-9E4B-082D1D452CA0}"/>
            </c:ext>
          </c:extLst>
        </c:ser>
        <c:ser>
          <c:idx val="5"/>
          <c:order val="2"/>
          <c:tx>
            <c:strRef>
              <c:f>'graph%'!$G$38</c:f>
              <c:strCache>
                <c:ptCount val="1"/>
                <c:pt idx="0">
                  <c:v>100 µg/m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raph%'!$H$39:$H$53</c:f>
                <c:numCache>
                  <c:formatCode>General</c:formatCode>
                  <c:ptCount val="15"/>
                  <c:pt idx="0">
                    <c:v>3.3961780540566222</c:v>
                  </c:pt>
                  <c:pt idx="1">
                    <c:v>0.66362099906853589</c:v>
                  </c:pt>
                  <c:pt idx="2">
                    <c:v>0.59725889916168218</c:v>
                  </c:pt>
                  <c:pt idx="3">
                    <c:v>0.82243628089690124</c:v>
                  </c:pt>
                  <c:pt idx="4">
                    <c:v>0.58200631974760653</c:v>
                  </c:pt>
                  <c:pt idx="5">
                    <c:v>1.603750747748961</c:v>
                  </c:pt>
                  <c:pt idx="6">
                    <c:v>1.612903225806452</c:v>
                  </c:pt>
                  <c:pt idx="7">
                    <c:v>8.7023357152673167E-15</c:v>
                  </c:pt>
                  <c:pt idx="8">
                    <c:v>1.8587715320029967</c:v>
                  </c:pt>
                  <c:pt idx="9">
                    <c:v>2.0619652471058094</c:v>
                  </c:pt>
                  <c:pt idx="10">
                    <c:v>0.89166064739710771</c:v>
                  </c:pt>
                  <c:pt idx="11">
                    <c:v>1.6037507477489608</c:v>
                  </c:pt>
                  <c:pt idx="12">
                    <c:v>0.48516829343666062</c:v>
                  </c:pt>
                  <c:pt idx="13">
                    <c:v>1.9533673245502683</c:v>
                  </c:pt>
                  <c:pt idx="14">
                    <c:v>0.43665146409299477</c:v>
                  </c:pt>
                </c:numCache>
              </c:numRef>
            </c:plus>
            <c:minus>
              <c:numRef>
                <c:f>'graph%'!$H$39:$H$53</c:f>
                <c:numCache>
                  <c:formatCode>General</c:formatCode>
                  <c:ptCount val="15"/>
                  <c:pt idx="0">
                    <c:v>3.3961780540566222</c:v>
                  </c:pt>
                  <c:pt idx="1">
                    <c:v>0.66362099906853589</c:v>
                  </c:pt>
                  <c:pt idx="2">
                    <c:v>0.59725889916168218</c:v>
                  </c:pt>
                  <c:pt idx="3">
                    <c:v>0.82243628089690124</c:v>
                  </c:pt>
                  <c:pt idx="4">
                    <c:v>0.58200631974760653</c:v>
                  </c:pt>
                  <c:pt idx="5">
                    <c:v>1.603750747748961</c:v>
                  </c:pt>
                  <c:pt idx="6">
                    <c:v>1.612903225806452</c:v>
                  </c:pt>
                  <c:pt idx="7">
                    <c:v>8.7023357152673167E-15</c:v>
                  </c:pt>
                  <c:pt idx="8">
                    <c:v>1.8587715320029967</c:v>
                  </c:pt>
                  <c:pt idx="9">
                    <c:v>2.0619652471058094</c:v>
                  </c:pt>
                  <c:pt idx="10">
                    <c:v>0.89166064739710771</c:v>
                  </c:pt>
                  <c:pt idx="11">
                    <c:v>1.6037507477489608</c:v>
                  </c:pt>
                  <c:pt idx="12">
                    <c:v>0.48516829343666062</c:v>
                  </c:pt>
                  <c:pt idx="13">
                    <c:v>1.9533673245502683</c:v>
                  </c:pt>
                  <c:pt idx="14">
                    <c:v>0.43665146409299477</c:v>
                  </c:pt>
                </c:numCache>
              </c:numRef>
            </c:minus>
          </c:errBars>
          <c:cat>
            <c:strRef>
              <c:f>'graph%'!$B$39:$B$53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'graph%'!$G$39:$G$53</c:f>
              <c:numCache>
                <c:formatCode>0.00</c:formatCode>
                <c:ptCount val="15"/>
                <c:pt idx="0">
                  <c:v>46.078431372549026</c:v>
                </c:pt>
                <c:pt idx="1">
                  <c:v>34.099616858237546</c:v>
                </c:pt>
                <c:pt idx="2">
                  <c:v>30.689655172413794</c:v>
                </c:pt>
                <c:pt idx="3">
                  <c:v>37.986704653371312</c:v>
                </c:pt>
                <c:pt idx="4">
                  <c:v>31.922043010752688</c:v>
                </c:pt>
                <c:pt idx="5">
                  <c:v>28.703703703703706</c:v>
                </c:pt>
                <c:pt idx="6">
                  <c:v>50</c:v>
                </c:pt>
                <c:pt idx="7">
                  <c:v>46.428571428571423</c:v>
                </c:pt>
                <c:pt idx="8">
                  <c:v>28.453453453453452</c:v>
                </c:pt>
                <c:pt idx="9">
                  <c:v>52.380952380952387</c:v>
                </c:pt>
                <c:pt idx="10">
                  <c:v>28.056628056628057</c:v>
                </c:pt>
                <c:pt idx="11">
                  <c:v>37.037037037037038</c:v>
                </c:pt>
                <c:pt idx="12">
                  <c:v>28.851540616246499</c:v>
                </c:pt>
                <c:pt idx="13">
                  <c:v>27.198879551820728</c:v>
                </c:pt>
                <c:pt idx="14">
                  <c:v>25.9663865546218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6CE-485B-9E4B-082D1D452CA0}"/>
            </c:ext>
          </c:extLst>
        </c:ser>
        <c:ser>
          <c:idx val="7"/>
          <c:order val="3"/>
          <c:tx>
            <c:strRef>
              <c:f>'graph%'!$I$38</c:f>
              <c:strCache>
                <c:ptCount val="1"/>
                <c:pt idx="0">
                  <c:v>50 µg/ml</c:v>
                </c:pt>
              </c:strCache>
            </c:strRef>
          </c:tx>
          <c:spPr>
            <a:solidFill>
              <a:srgbClr val="D02EC8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raph%'!$J$39:$J$53</c:f>
                <c:numCache>
                  <c:formatCode>General</c:formatCode>
                  <c:ptCount val="15"/>
                  <c:pt idx="0">
                    <c:v>2.3773246378396342</c:v>
                  </c:pt>
                  <c:pt idx="1">
                    <c:v>1.724137931034484</c:v>
                  </c:pt>
                  <c:pt idx="2">
                    <c:v>2.4865870865268911</c:v>
                  </c:pt>
                  <c:pt idx="3">
                    <c:v>3.3719887516773044</c:v>
                  </c:pt>
                  <c:pt idx="4">
                    <c:v>0.64020695172236763</c:v>
                  </c:pt>
                  <c:pt idx="5">
                    <c:v>0</c:v>
                  </c:pt>
                  <c:pt idx="6">
                    <c:v>1.6140975267666962</c:v>
                  </c:pt>
                  <c:pt idx="7">
                    <c:v>2.0619652471058094</c:v>
                  </c:pt>
                  <c:pt idx="8">
                    <c:v>0.39010153323623453</c:v>
                  </c:pt>
                  <c:pt idx="9">
                    <c:v>0</c:v>
                  </c:pt>
                  <c:pt idx="10">
                    <c:v>1.4266570358353701</c:v>
                  </c:pt>
                  <c:pt idx="11">
                    <c:v>0</c:v>
                  </c:pt>
                  <c:pt idx="12">
                    <c:v>0.58220195212399439</c:v>
                  </c:pt>
                  <c:pt idx="13">
                    <c:v>0.63071878146765625</c:v>
                  </c:pt>
                  <c:pt idx="14">
                    <c:v>2.1821789023599232</c:v>
                  </c:pt>
                </c:numCache>
              </c:numRef>
            </c:plus>
            <c:minus>
              <c:numRef>
                <c:f>'graph%'!$J$39:$J$53</c:f>
                <c:numCache>
                  <c:formatCode>General</c:formatCode>
                  <c:ptCount val="15"/>
                  <c:pt idx="0">
                    <c:v>2.3773246378396342</c:v>
                  </c:pt>
                  <c:pt idx="1">
                    <c:v>1.724137931034484</c:v>
                  </c:pt>
                  <c:pt idx="2">
                    <c:v>2.4865870865268911</c:v>
                  </c:pt>
                  <c:pt idx="3">
                    <c:v>3.3719887516773044</c:v>
                  </c:pt>
                  <c:pt idx="4">
                    <c:v>0.64020695172236763</c:v>
                  </c:pt>
                  <c:pt idx="5">
                    <c:v>0</c:v>
                  </c:pt>
                  <c:pt idx="6">
                    <c:v>1.6140975267666962</c:v>
                  </c:pt>
                  <c:pt idx="7">
                    <c:v>2.0619652471058094</c:v>
                  </c:pt>
                  <c:pt idx="8">
                    <c:v>0.39010153323623453</c:v>
                  </c:pt>
                  <c:pt idx="9">
                    <c:v>0</c:v>
                  </c:pt>
                  <c:pt idx="10">
                    <c:v>1.4266570358353701</c:v>
                  </c:pt>
                  <c:pt idx="11">
                    <c:v>0</c:v>
                  </c:pt>
                  <c:pt idx="12">
                    <c:v>0.58220195212399439</c:v>
                  </c:pt>
                  <c:pt idx="13">
                    <c:v>0.63071878146765625</c:v>
                  </c:pt>
                  <c:pt idx="14">
                    <c:v>2.1821789023599232</c:v>
                  </c:pt>
                </c:numCache>
              </c:numRef>
            </c:minus>
          </c:errBars>
          <c:cat>
            <c:strRef>
              <c:f>'graph%'!$B$39:$B$53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'graph%'!$I$39:$I$53</c:f>
              <c:numCache>
                <c:formatCode>0.00</c:formatCode>
                <c:ptCount val="15"/>
                <c:pt idx="0">
                  <c:v>37.843137254901961</c:v>
                </c:pt>
                <c:pt idx="1">
                  <c:v>50</c:v>
                </c:pt>
                <c:pt idx="2">
                  <c:v>42.068965517241381</c:v>
                </c:pt>
                <c:pt idx="3">
                  <c:v>55.745489078822409</c:v>
                </c:pt>
                <c:pt idx="4">
                  <c:v>35.11424731182796</c:v>
                </c:pt>
                <c:pt idx="5">
                  <c:v>30.555555555555557</c:v>
                </c:pt>
                <c:pt idx="6">
                  <c:v>46.738351254480278</c:v>
                </c:pt>
                <c:pt idx="7">
                  <c:v>38.095238095238095</c:v>
                </c:pt>
                <c:pt idx="8">
                  <c:v>24.774774774774773</c:v>
                </c:pt>
                <c:pt idx="9">
                  <c:v>39.285714285714292</c:v>
                </c:pt>
                <c:pt idx="10">
                  <c:v>44.890604890604891</c:v>
                </c:pt>
                <c:pt idx="11">
                  <c:v>30.555555555555557</c:v>
                </c:pt>
                <c:pt idx="12">
                  <c:v>34.621848739495796</c:v>
                </c:pt>
                <c:pt idx="13">
                  <c:v>37.871148459383754</c:v>
                </c:pt>
                <c:pt idx="14">
                  <c:v>48.0952380952380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36CE-485B-9E4B-082D1D452CA0}"/>
            </c:ext>
          </c:extLst>
        </c:ser>
        <c:ser>
          <c:idx val="9"/>
          <c:order val="4"/>
          <c:tx>
            <c:strRef>
              <c:f>'graph%'!$K$38</c:f>
              <c:strCache>
                <c:ptCount val="1"/>
                <c:pt idx="0">
                  <c:v>10 µg/m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raph%'!$L$39:$L$53</c:f>
                <c:numCache>
                  <c:formatCode>General</c:formatCode>
                  <c:ptCount val="15"/>
                  <c:pt idx="0">
                    <c:v>1.964049568799568</c:v>
                  </c:pt>
                  <c:pt idx="1">
                    <c:v>1.1281556984165109</c:v>
                  </c:pt>
                  <c:pt idx="2">
                    <c:v>0.79634519888224298</c:v>
                  </c:pt>
                  <c:pt idx="3">
                    <c:v>0.90467990898658845</c:v>
                  </c:pt>
                  <c:pt idx="4">
                    <c:v>2.5528790205944323</c:v>
                  </c:pt>
                  <c:pt idx="5">
                    <c:v>0</c:v>
                  </c:pt>
                  <c:pt idx="6">
                    <c:v>1.2416134821282305</c:v>
                  </c:pt>
                  <c:pt idx="7">
                    <c:v>2.061965247105805</c:v>
                  </c:pt>
                  <c:pt idx="8">
                    <c:v>1.3931096756473258</c:v>
                  </c:pt>
                  <c:pt idx="9">
                    <c:v>0</c:v>
                  </c:pt>
                  <c:pt idx="10">
                    <c:v>2.6664231688195925</c:v>
                  </c:pt>
                  <c:pt idx="11">
                    <c:v>1.603750747748961</c:v>
                  </c:pt>
                  <c:pt idx="12">
                    <c:v>0.72775244015499196</c:v>
                  </c:pt>
                  <c:pt idx="13">
                    <c:v>0.72775244015499196</c:v>
                  </c:pt>
                  <c:pt idx="14">
                    <c:v>1.4359670160197515</c:v>
                  </c:pt>
                </c:numCache>
              </c:numRef>
            </c:plus>
            <c:minus>
              <c:numRef>
                <c:f>'graph%'!$L$39:$L$53</c:f>
                <c:numCache>
                  <c:formatCode>General</c:formatCode>
                  <c:ptCount val="15"/>
                  <c:pt idx="0">
                    <c:v>1.964049568799568</c:v>
                  </c:pt>
                  <c:pt idx="1">
                    <c:v>1.1281556984165109</c:v>
                  </c:pt>
                  <c:pt idx="2">
                    <c:v>0.79634519888224298</c:v>
                  </c:pt>
                  <c:pt idx="3">
                    <c:v>0.90467990898658845</c:v>
                  </c:pt>
                  <c:pt idx="4">
                    <c:v>2.5528790205944323</c:v>
                  </c:pt>
                  <c:pt idx="5">
                    <c:v>0</c:v>
                  </c:pt>
                  <c:pt idx="6">
                    <c:v>1.2416134821282305</c:v>
                  </c:pt>
                  <c:pt idx="7">
                    <c:v>2.061965247105805</c:v>
                  </c:pt>
                  <c:pt idx="8">
                    <c:v>1.3931096756473258</c:v>
                  </c:pt>
                  <c:pt idx="9">
                    <c:v>0</c:v>
                  </c:pt>
                  <c:pt idx="10">
                    <c:v>2.6664231688195925</c:v>
                  </c:pt>
                  <c:pt idx="11">
                    <c:v>1.603750747748961</c:v>
                  </c:pt>
                  <c:pt idx="12">
                    <c:v>0.72775244015499196</c:v>
                  </c:pt>
                  <c:pt idx="13">
                    <c:v>0.72775244015499196</c:v>
                  </c:pt>
                  <c:pt idx="14">
                    <c:v>1.4359670160197515</c:v>
                  </c:pt>
                </c:numCache>
              </c:numRef>
            </c:minus>
          </c:errBars>
          <c:cat>
            <c:strRef>
              <c:f>'graph%'!$B$39:$B$53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'graph%'!$K$39:$K$53</c:f>
              <c:numCache>
                <c:formatCode>0.00</c:formatCode>
                <c:ptCount val="15"/>
                <c:pt idx="0">
                  <c:v>55.16339869281046</c:v>
                </c:pt>
                <c:pt idx="1">
                  <c:v>57.969348659003828</c:v>
                </c:pt>
                <c:pt idx="2">
                  <c:v>40.919540229885058</c:v>
                </c:pt>
                <c:pt idx="3">
                  <c:v>58.214624881291549</c:v>
                </c:pt>
                <c:pt idx="4">
                  <c:v>58.534946236559136</c:v>
                </c:pt>
                <c:pt idx="5">
                  <c:v>52.777777777777779</c:v>
                </c:pt>
                <c:pt idx="6">
                  <c:v>65.232974910394262</c:v>
                </c:pt>
                <c:pt idx="7">
                  <c:v>69.047619047619051</c:v>
                </c:pt>
                <c:pt idx="8">
                  <c:v>43.118118118118112</c:v>
                </c:pt>
                <c:pt idx="9">
                  <c:v>64.285714285714292</c:v>
                </c:pt>
                <c:pt idx="10">
                  <c:v>45.842985842985833</c:v>
                </c:pt>
                <c:pt idx="11">
                  <c:v>49.074074074074076</c:v>
                </c:pt>
                <c:pt idx="12">
                  <c:v>43.277310924369743</c:v>
                </c:pt>
                <c:pt idx="13">
                  <c:v>43.697478991596633</c:v>
                </c:pt>
                <c:pt idx="14">
                  <c:v>41.3445378151260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36CE-485B-9E4B-082D1D452CA0}"/>
            </c:ext>
          </c:extLst>
        </c:ser>
        <c:ser>
          <c:idx val="11"/>
          <c:order val="5"/>
          <c:tx>
            <c:strRef>
              <c:f>'graph%'!$M$38</c:f>
              <c:strCache>
                <c:ptCount val="1"/>
                <c:pt idx="0">
                  <c:v>5 µg/ml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raph%'!$N$39:$N$53</c:f>
                <c:numCache>
                  <c:formatCode>General</c:formatCode>
                  <c:ptCount val="15"/>
                  <c:pt idx="0">
                    <c:v>2.3094010767585034</c:v>
                  </c:pt>
                  <c:pt idx="1">
                    <c:v>4.1201418572205606</c:v>
                  </c:pt>
                  <c:pt idx="2">
                    <c:v>2.5458753860865788</c:v>
                  </c:pt>
                  <c:pt idx="3">
                    <c:v>2.4056261216234436</c:v>
                  </c:pt>
                  <c:pt idx="4">
                    <c:v>7.8864020385757501</c:v>
                  </c:pt>
                  <c:pt idx="5">
                    <c:v>5.234219473422427</c:v>
                  </c:pt>
                  <c:pt idx="6">
                    <c:v>3.205126649580158</c:v>
                  </c:pt>
                  <c:pt idx="7">
                    <c:v>4.0000000000000071</c:v>
                  </c:pt>
                  <c:pt idx="8">
                    <c:v>1.3272419981370718</c:v>
                  </c:pt>
                  <c:pt idx="9">
                    <c:v>2.122482265289733</c:v>
                  </c:pt>
                  <c:pt idx="10">
                    <c:v>1.5626289337041195</c:v>
                  </c:pt>
                  <c:pt idx="11">
                    <c:v>1.2608798982302181</c:v>
                  </c:pt>
                  <c:pt idx="12">
                    <c:v>1.6223263043781333</c:v>
                  </c:pt>
                  <c:pt idx="13">
                    <c:v>1.3272419981370718</c:v>
                  </c:pt>
                  <c:pt idx="14">
                    <c:v>1.8282758524338176</c:v>
                  </c:pt>
                </c:numCache>
              </c:numRef>
            </c:plus>
            <c:minus>
              <c:numRef>
                <c:f>'graph%'!$N$39:$N$53</c:f>
                <c:numCache>
                  <c:formatCode>General</c:formatCode>
                  <c:ptCount val="15"/>
                  <c:pt idx="0">
                    <c:v>2.3094010767585034</c:v>
                  </c:pt>
                  <c:pt idx="1">
                    <c:v>4.1201418572205606</c:v>
                  </c:pt>
                  <c:pt idx="2">
                    <c:v>2.5458753860865788</c:v>
                  </c:pt>
                  <c:pt idx="3">
                    <c:v>2.4056261216234436</c:v>
                  </c:pt>
                  <c:pt idx="4">
                    <c:v>7.8864020385757501</c:v>
                  </c:pt>
                  <c:pt idx="5">
                    <c:v>5.234219473422427</c:v>
                  </c:pt>
                  <c:pt idx="6">
                    <c:v>3.205126649580158</c:v>
                  </c:pt>
                  <c:pt idx="7">
                    <c:v>4.0000000000000071</c:v>
                  </c:pt>
                  <c:pt idx="8">
                    <c:v>1.3272419981370718</c:v>
                  </c:pt>
                  <c:pt idx="9">
                    <c:v>2.122482265289733</c:v>
                  </c:pt>
                  <c:pt idx="10">
                    <c:v>1.5626289337041195</c:v>
                  </c:pt>
                  <c:pt idx="11">
                    <c:v>1.2608798982302181</c:v>
                  </c:pt>
                  <c:pt idx="12">
                    <c:v>1.6223263043781333</c:v>
                  </c:pt>
                  <c:pt idx="13">
                    <c:v>1.3272419981370718</c:v>
                  </c:pt>
                  <c:pt idx="14">
                    <c:v>1.8282758524338176</c:v>
                  </c:pt>
                </c:numCache>
              </c:numRef>
            </c:minus>
          </c:errBars>
          <c:cat>
            <c:strRef>
              <c:f>'graph%'!$B$39:$B$53</c:f>
              <c:strCache>
                <c:ptCount val="15"/>
                <c:pt idx="0">
                  <c:v>F. verticillioides 604</c:v>
                </c:pt>
                <c:pt idx="1">
                  <c:v>F. verticillioides 86</c:v>
                </c:pt>
                <c:pt idx="2">
                  <c:v>F. verticillioides 87</c:v>
                </c:pt>
                <c:pt idx="3">
                  <c:v>F. veticillioides 84</c:v>
                </c:pt>
                <c:pt idx="4">
                  <c:v>F. veticillioides 83</c:v>
                </c:pt>
                <c:pt idx="5">
                  <c:v>F. verticillioides 88</c:v>
                </c:pt>
                <c:pt idx="6">
                  <c:v>F. solani 94</c:v>
                </c:pt>
                <c:pt idx="7">
                  <c:v> F. solani 96</c:v>
                </c:pt>
                <c:pt idx="8">
                  <c:v>F. solani  502</c:v>
                </c:pt>
                <c:pt idx="9">
                  <c:v>F. solani 93</c:v>
                </c:pt>
                <c:pt idx="10">
                  <c:v> F. oxysporum 89</c:v>
                </c:pt>
                <c:pt idx="11">
                  <c:v>F. oxysporum  516</c:v>
                </c:pt>
                <c:pt idx="12">
                  <c:v>F. oxysporum 92</c:v>
                </c:pt>
                <c:pt idx="13">
                  <c:v>F. oxysporum 90</c:v>
                </c:pt>
                <c:pt idx="14">
                  <c:v>F. oxysporum 91</c:v>
                </c:pt>
              </c:strCache>
            </c:strRef>
          </c:cat>
          <c:val>
            <c:numRef>
              <c:f>'graph%'!$M$39:$M$53</c:f>
              <c:numCache>
                <c:formatCode>0.00</c:formatCode>
                <c:ptCount val="15"/>
                <c:pt idx="0">
                  <c:v>73.333333333333329</c:v>
                </c:pt>
                <c:pt idx="1">
                  <c:v>76.984126984126974</c:v>
                </c:pt>
                <c:pt idx="2">
                  <c:v>67.222222222222214</c:v>
                </c:pt>
                <c:pt idx="3">
                  <c:v>77.777777777777786</c:v>
                </c:pt>
                <c:pt idx="4">
                  <c:v>84.753623188405797</c:v>
                </c:pt>
                <c:pt idx="5">
                  <c:v>73.901098901098905</c:v>
                </c:pt>
                <c:pt idx="6">
                  <c:v>82.594417077175706</c:v>
                </c:pt>
                <c:pt idx="7">
                  <c:v>84</c:v>
                </c:pt>
                <c:pt idx="8">
                  <c:v>68.199233716475092</c:v>
                </c:pt>
                <c:pt idx="9">
                  <c:v>81.589743589743591</c:v>
                </c:pt>
                <c:pt idx="10">
                  <c:v>72.1747388414055</c:v>
                </c:pt>
                <c:pt idx="11">
                  <c:v>64.789272030651347</c:v>
                </c:pt>
                <c:pt idx="12">
                  <c:v>59.576612903225801</c:v>
                </c:pt>
                <c:pt idx="13">
                  <c:v>67.432950191570896</c:v>
                </c:pt>
                <c:pt idx="14">
                  <c:v>77.0555555555555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36CE-485B-9E4B-082D1D452CA0}"/>
            </c:ext>
          </c:extLst>
        </c:ser>
        <c:ser>
          <c:idx val="0"/>
          <c:order val="6"/>
          <c:tx>
            <c:strRef>
              <c:f>'graph%'!$O$38</c:f>
              <c:strCache>
                <c:ptCount val="1"/>
                <c:pt idx="0">
                  <c:v>0 µg/ml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"/>
          </c:errBars>
          <c:val>
            <c:numRef>
              <c:f>'graph%'!$O$39:$O$53</c:f>
              <c:numCache>
                <c:formatCode>General</c:formatCode>
                <c:ptCount val="1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878-4AAB-A52F-6D8E3BBE32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2489584"/>
        <c:axId val="302490760"/>
      </c:barChart>
      <c:catAx>
        <c:axId val="302489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5400000" vert="horz"/>
          <a:lstStyle/>
          <a:p>
            <a:pPr>
              <a:defRPr sz="800">
                <a:latin typeface="+mn-lt"/>
                <a:cs typeface="Times New Roman" panose="02020603050405020304" pitchFamily="18" charset="0"/>
              </a:defRPr>
            </a:pPr>
            <a:endParaRPr lang="it-IT"/>
          </a:p>
        </c:txPr>
        <c:crossAx val="302490760"/>
        <c:crosses val="autoZero"/>
        <c:auto val="1"/>
        <c:lblAlgn val="ctr"/>
        <c:lblOffset val="100"/>
        <c:noMultiLvlLbl val="0"/>
      </c:catAx>
      <c:valAx>
        <c:axId val="302490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 sz="800"/>
                  <a:t>Colony diameter</a:t>
                </a:r>
                <a:r>
                  <a:rPr lang="en-GB" sz="800" baseline="0"/>
                  <a:t> (% relative to control)</a:t>
                </a:r>
                <a:endParaRPr lang="en-GB" sz="800"/>
              </a:p>
            </c:rich>
          </c:tx>
          <c:layout>
            <c:manualLayout>
              <c:xMode val="edge"/>
              <c:yMode val="edge"/>
              <c:x val="7.3734968230423376E-3"/>
              <c:y val="0.3189344742854609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024895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93172649866533597"/>
          <c:y val="0.38606638021310352"/>
          <c:w val="6.7312255387994985E-2"/>
          <c:h val="0.28700881390522115"/>
        </c:manualLayout>
      </c:layout>
      <c:overlay val="0"/>
      <c:txPr>
        <a:bodyPr/>
        <a:lstStyle/>
        <a:p>
          <a:pPr>
            <a:defRPr sz="800">
              <a:latin typeface="+mn-lt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txPr>
    <a:bodyPr/>
    <a:lstStyle/>
    <a:p>
      <a:pPr>
        <a:defRPr sz="1000"/>
      </a:pPr>
      <a:endParaRPr lang="it-IT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1399</cdr:x>
      <cdr:y>0.12809</cdr:y>
    </cdr:from>
    <cdr:to>
      <cdr:x>0.93933</cdr:x>
      <cdr:y>0.15437</cdr:y>
    </cdr:to>
    <cdr:sp macro="" textlink="">
      <cdr:nvSpPr>
        <cdr:cNvPr id="2" name="CasellaDiTesto 1"/>
        <cdr:cNvSpPr txBox="1"/>
      </cdr:nvSpPr>
      <cdr:spPr>
        <a:xfrm xmlns:a="http://schemas.openxmlformats.org/drawingml/2006/main">
          <a:off x="8932127" y="1004072"/>
          <a:ext cx="247639" cy="2060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045</cdr:x>
      <cdr:y>0.52868</cdr:y>
    </cdr:from>
    <cdr:to>
      <cdr:x>0.06823</cdr:x>
      <cdr:y>0.57073</cdr:y>
    </cdr:to>
    <cdr:sp macro="" textlink="">
      <cdr:nvSpPr>
        <cdr:cNvPr id="3" name="CasellaDiTesto 2"/>
        <cdr:cNvSpPr txBox="1"/>
      </cdr:nvSpPr>
      <cdr:spPr>
        <a:xfrm xmlns:a="http://schemas.openxmlformats.org/drawingml/2006/main">
          <a:off x="439801" y="4144329"/>
          <a:ext cx="227019" cy="3296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05158</cdr:x>
      <cdr:y>0.47023</cdr:y>
    </cdr:from>
    <cdr:to>
      <cdr:x>0.08674</cdr:x>
      <cdr:y>0.50503</cdr:y>
    </cdr:to>
    <cdr:sp macro="" textlink="">
      <cdr:nvSpPr>
        <cdr:cNvPr id="4" name="CasellaDiTesto 3"/>
        <cdr:cNvSpPr txBox="1"/>
      </cdr:nvSpPr>
      <cdr:spPr>
        <a:xfrm xmlns:a="http://schemas.openxmlformats.org/drawingml/2006/main">
          <a:off x="504066" y="3686179"/>
          <a:ext cx="343660" cy="2727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05848</cdr:x>
      <cdr:y>0.44714</cdr:y>
    </cdr:from>
    <cdr:to>
      <cdr:x>0.09029</cdr:x>
      <cdr:y>0.50434</cdr:y>
    </cdr:to>
    <cdr:sp macro="" textlink="">
      <cdr:nvSpPr>
        <cdr:cNvPr id="5" name="CasellaDiTesto 4"/>
        <cdr:cNvSpPr txBox="1"/>
      </cdr:nvSpPr>
      <cdr:spPr>
        <a:xfrm xmlns:a="http://schemas.openxmlformats.org/drawingml/2006/main" rot="16200000">
          <a:off x="502761" y="3573945"/>
          <a:ext cx="448355" cy="3108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d</a:t>
          </a:r>
        </a:p>
      </cdr:txBody>
    </cdr:sp>
  </cdr:relSizeAnchor>
  <cdr:relSizeAnchor xmlns:cdr="http://schemas.openxmlformats.org/drawingml/2006/chartDrawing">
    <cdr:from>
      <cdr:x>0.06717</cdr:x>
      <cdr:y>0.532</cdr:y>
    </cdr:from>
    <cdr:to>
      <cdr:x>0.09463</cdr:x>
      <cdr:y>0.57405</cdr:y>
    </cdr:to>
    <cdr:sp macro="" textlink="">
      <cdr:nvSpPr>
        <cdr:cNvPr id="6" name="CasellaDiTesto 5"/>
        <cdr:cNvSpPr txBox="1"/>
      </cdr:nvSpPr>
      <cdr:spPr>
        <a:xfrm xmlns:a="http://schemas.openxmlformats.org/drawingml/2006/main">
          <a:off x="656461" y="4170390"/>
          <a:ext cx="268357" cy="3296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07367</cdr:x>
      <cdr:y>0.41798</cdr:y>
    </cdr:from>
    <cdr:to>
      <cdr:x>0.10136</cdr:x>
      <cdr:y>0.45216</cdr:y>
    </cdr:to>
    <cdr:sp macro="" textlink="">
      <cdr:nvSpPr>
        <cdr:cNvPr id="7" name="CasellaDiTesto 6"/>
        <cdr:cNvSpPr txBox="1"/>
      </cdr:nvSpPr>
      <cdr:spPr>
        <a:xfrm xmlns:a="http://schemas.openxmlformats.org/drawingml/2006/main">
          <a:off x="719990" y="3276604"/>
          <a:ext cx="270611" cy="2679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07984</cdr:x>
      <cdr:y>0.28818</cdr:y>
    </cdr:from>
    <cdr:to>
      <cdr:x>0.09885</cdr:x>
      <cdr:y>0.32366</cdr:y>
    </cdr:to>
    <cdr:sp macro="" textlink="">
      <cdr:nvSpPr>
        <cdr:cNvPr id="8" name="CasellaDiTesto 7"/>
        <cdr:cNvSpPr txBox="1"/>
      </cdr:nvSpPr>
      <cdr:spPr>
        <a:xfrm xmlns:a="http://schemas.openxmlformats.org/drawingml/2006/main">
          <a:off x="780281" y="2259063"/>
          <a:ext cx="185778" cy="2781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08911</cdr:x>
      <cdr:y>0.12211</cdr:y>
    </cdr:from>
    <cdr:to>
      <cdr:x>0.10917</cdr:x>
      <cdr:y>0.15102</cdr:y>
    </cdr:to>
    <cdr:sp macro="" textlink="">
      <cdr:nvSpPr>
        <cdr:cNvPr id="9" name="CasellaDiTesto 8"/>
        <cdr:cNvSpPr txBox="1"/>
      </cdr:nvSpPr>
      <cdr:spPr>
        <a:xfrm xmlns:a="http://schemas.openxmlformats.org/drawingml/2006/main">
          <a:off x="870809" y="957191"/>
          <a:ext cx="196039" cy="2266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0624</cdr:x>
      <cdr:y>0.65204</cdr:y>
    </cdr:from>
    <cdr:to>
      <cdr:x>0.1337</cdr:x>
      <cdr:y>0.68095</cdr:y>
    </cdr:to>
    <cdr:sp macro="" textlink="">
      <cdr:nvSpPr>
        <cdr:cNvPr id="10" name="CasellaDiTesto 9"/>
        <cdr:cNvSpPr txBox="1"/>
      </cdr:nvSpPr>
      <cdr:spPr>
        <a:xfrm xmlns:a="http://schemas.openxmlformats.org/drawingml/2006/main">
          <a:off x="1038279" y="5446782"/>
          <a:ext cx="268357" cy="2414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f</a:t>
          </a:r>
        </a:p>
      </cdr:txBody>
    </cdr:sp>
  </cdr:relSizeAnchor>
  <cdr:relSizeAnchor xmlns:cdr="http://schemas.openxmlformats.org/drawingml/2006/chartDrawing">
    <cdr:from>
      <cdr:x>0.1125</cdr:x>
      <cdr:y>0.56619</cdr:y>
    </cdr:from>
    <cdr:to>
      <cdr:x>0.15263</cdr:x>
      <cdr:y>0.59247</cdr:y>
    </cdr:to>
    <cdr:sp macro="" textlink="">
      <cdr:nvSpPr>
        <cdr:cNvPr id="11" name="CasellaDiTesto 10"/>
        <cdr:cNvSpPr txBox="1"/>
      </cdr:nvSpPr>
      <cdr:spPr>
        <a:xfrm xmlns:a="http://schemas.openxmlformats.org/drawingml/2006/main">
          <a:off x="1099403" y="4729630"/>
          <a:ext cx="392177" cy="2195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e</a:t>
          </a:r>
        </a:p>
      </cdr:txBody>
    </cdr:sp>
  </cdr:relSizeAnchor>
  <cdr:relSizeAnchor xmlns:cdr="http://schemas.openxmlformats.org/drawingml/2006/chartDrawing">
    <cdr:from>
      <cdr:x>0.1255</cdr:x>
      <cdr:y>0.45154</cdr:y>
    </cdr:from>
    <cdr:to>
      <cdr:x>0.15205</cdr:x>
      <cdr:y>0.47718</cdr:y>
    </cdr:to>
    <cdr:sp macro="" textlink="">
      <cdr:nvSpPr>
        <cdr:cNvPr id="12" name="CasellaDiTesto 11"/>
        <cdr:cNvSpPr txBox="1"/>
      </cdr:nvSpPr>
      <cdr:spPr>
        <a:xfrm xmlns:a="http://schemas.openxmlformats.org/drawingml/2006/main">
          <a:off x="1226461" y="3771903"/>
          <a:ext cx="259440" cy="2141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13362</cdr:x>
      <cdr:y>0.40272</cdr:y>
    </cdr:from>
    <cdr:to>
      <cdr:x>0.15157</cdr:x>
      <cdr:y>0.43032</cdr:y>
    </cdr:to>
    <cdr:sp macro="" textlink="">
      <cdr:nvSpPr>
        <cdr:cNvPr id="13" name="CasellaDiTesto 12"/>
        <cdr:cNvSpPr txBox="1"/>
      </cdr:nvSpPr>
      <cdr:spPr>
        <a:xfrm xmlns:a="http://schemas.openxmlformats.org/drawingml/2006/main">
          <a:off x="1305802" y="3364101"/>
          <a:ext cx="175419" cy="2305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13914</cdr:x>
      <cdr:y>0.2523</cdr:y>
    </cdr:from>
    <cdr:to>
      <cdr:x>0.16237</cdr:x>
      <cdr:y>0.27727</cdr:y>
    </cdr:to>
    <cdr:sp macro="" textlink="">
      <cdr:nvSpPr>
        <cdr:cNvPr id="14" name="CasellaDiTesto 13"/>
        <cdr:cNvSpPr txBox="1"/>
      </cdr:nvSpPr>
      <cdr:spPr>
        <a:xfrm xmlns:a="http://schemas.openxmlformats.org/drawingml/2006/main">
          <a:off x="1359806" y="2107570"/>
          <a:ext cx="227018" cy="2085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14646</cdr:x>
      <cdr:y>0.12343</cdr:y>
    </cdr:from>
    <cdr:to>
      <cdr:x>0.16863</cdr:x>
      <cdr:y>0.14971</cdr:y>
    </cdr:to>
    <cdr:sp macro="" textlink="">
      <cdr:nvSpPr>
        <cdr:cNvPr id="15" name="CasellaDiTesto 14"/>
        <cdr:cNvSpPr txBox="1"/>
      </cdr:nvSpPr>
      <cdr:spPr>
        <a:xfrm xmlns:a="http://schemas.openxmlformats.org/drawingml/2006/main">
          <a:off x="1431284" y="967539"/>
          <a:ext cx="216659" cy="2060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16335</cdr:x>
      <cdr:y>0.69873</cdr:y>
    </cdr:from>
    <cdr:to>
      <cdr:x>0.18236</cdr:x>
      <cdr:y>0.72501</cdr:y>
    </cdr:to>
    <cdr:sp macro="" textlink="">
      <cdr:nvSpPr>
        <cdr:cNvPr id="16" name="CasellaDiTesto 15"/>
        <cdr:cNvSpPr txBox="1"/>
      </cdr:nvSpPr>
      <cdr:spPr>
        <a:xfrm xmlns:a="http://schemas.openxmlformats.org/drawingml/2006/main">
          <a:off x="1596349" y="5836796"/>
          <a:ext cx="185778" cy="2195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17058</cdr:x>
      <cdr:y>0.5943</cdr:y>
    </cdr:from>
    <cdr:to>
      <cdr:x>0.21071</cdr:x>
      <cdr:y>0.62847</cdr:y>
    </cdr:to>
    <cdr:sp macro="" textlink="">
      <cdr:nvSpPr>
        <cdr:cNvPr id="17" name="CasellaDiTesto 16"/>
        <cdr:cNvSpPr txBox="1"/>
      </cdr:nvSpPr>
      <cdr:spPr>
        <a:xfrm xmlns:a="http://schemas.openxmlformats.org/drawingml/2006/main">
          <a:off x="1666999" y="4964439"/>
          <a:ext cx="392176" cy="2854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d</a:t>
          </a:r>
        </a:p>
      </cdr:txBody>
    </cdr:sp>
  </cdr:relSizeAnchor>
  <cdr:relSizeAnchor xmlns:cdr="http://schemas.openxmlformats.org/drawingml/2006/chartDrawing">
    <cdr:from>
      <cdr:x>0.18122</cdr:x>
      <cdr:y>0.50232</cdr:y>
    </cdr:from>
    <cdr:to>
      <cdr:x>0.22979</cdr:x>
      <cdr:y>0.53386</cdr:y>
    </cdr:to>
    <cdr:sp macro="" textlink="">
      <cdr:nvSpPr>
        <cdr:cNvPr id="18" name="CasellaDiTesto 17"/>
        <cdr:cNvSpPr txBox="1"/>
      </cdr:nvSpPr>
      <cdr:spPr>
        <a:xfrm xmlns:a="http://schemas.openxmlformats.org/drawingml/2006/main">
          <a:off x="1771032" y="4196090"/>
          <a:ext cx="474658" cy="2634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100"/>
            <a:t> </a:t>
          </a:r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1943</cdr:x>
      <cdr:y>0.3272</cdr:y>
    </cdr:from>
    <cdr:to>
      <cdr:x>0.22703</cdr:x>
      <cdr:y>0.36137</cdr:y>
    </cdr:to>
    <cdr:sp macro="" textlink="">
      <cdr:nvSpPr>
        <cdr:cNvPr id="19" name="CasellaDiTesto 18"/>
        <cdr:cNvSpPr txBox="1"/>
      </cdr:nvSpPr>
      <cdr:spPr>
        <a:xfrm xmlns:a="http://schemas.openxmlformats.org/drawingml/2006/main">
          <a:off x="1752600" y="2371726"/>
          <a:ext cx="295275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064</cdr:x>
      <cdr:y>0.12343</cdr:y>
    </cdr:from>
    <cdr:to>
      <cdr:x>0.22857</cdr:x>
      <cdr:y>0.15102</cdr:y>
    </cdr:to>
    <cdr:sp macro="" textlink="">
      <cdr:nvSpPr>
        <cdr:cNvPr id="20" name="CasellaDiTesto 19"/>
        <cdr:cNvSpPr txBox="1"/>
      </cdr:nvSpPr>
      <cdr:spPr>
        <a:xfrm xmlns:a="http://schemas.openxmlformats.org/drawingml/2006/main">
          <a:off x="2017095" y="967539"/>
          <a:ext cx="216660" cy="2162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224</cdr:x>
      <cdr:y>0.63873</cdr:y>
    </cdr:from>
    <cdr:to>
      <cdr:x>0.2488</cdr:x>
      <cdr:y>0.68078</cdr:y>
    </cdr:to>
    <cdr:sp macro="" textlink="">
      <cdr:nvSpPr>
        <cdr:cNvPr id="21" name="CasellaDiTesto 20"/>
        <cdr:cNvSpPr txBox="1"/>
      </cdr:nvSpPr>
      <cdr:spPr>
        <a:xfrm xmlns:a="http://schemas.openxmlformats.org/drawingml/2006/main">
          <a:off x="2173470" y="5335600"/>
          <a:ext cx="257998" cy="3512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22784</cdr:x>
      <cdr:y>0.5166</cdr:y>
    </cdr:from>
    <cdr:to>
      <cdr:x>0.27325</cdr:x>
      <cdr:y>0.54814</cdr:y>
    </cdr:to>
    <cdr:sp macro="" textlink="">
      <cdr:nvSpPr>
        <cdr:cNvPr id="22" name="CasellaDiTesto 21"/>
        <cdr:cNvSpPr txBox="1"/>
      </cdr:nvSpPr>
      <cdr:spPr>
        <a:xfrm xmlns:a="http://schemas.openxmlformats.org/drawingml/2006/main">
          <a:off x="2226640" y="4315379"/>
          <a:ext cx="443776" cy="2634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 d</a:t>
          </a:r>
        </a:p>
      </cdr:txBody>
    </cdr:sp>
  </cdr:relSizeAnchor>
  <cdr:relSizeAnchor xmlns:cdr="http://schemas.openxmlformats.org/drawingml/2006/chartDrawing">
    <cdr:from>
      <cdr:x>0.24328</cdr:x>
      <cdr:y>0.40131</cdr:y>
    </cdr:from>
    <cdr:to>
      <cdr:x>0.28551</cdr:x>
      <cdr:y>0.43547</cdr:y>
    </cdr:to>
    <cdr:sp macro="" textlink="">
      <cdr:nvSpPr>
        <cdr:cNvPr id="23" name="CasellaDiTesto 22"/>
        <cdr:cNvSpPr txBox="1"/>
      </cdr:nvSpPr>
      <cdr:spPr>
        <a:xfrm xmlns:a="http://schemas.openxmlformats.org/drawingml/2006/main">
          <a:off x="2377464" y="3352308"/>
          <a:ext cx="412699" cy="2853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c</a:t>
          </a:r>
        </a:p>
      </cdr:txBody>
    </cdr:sp>
  </cdr:relSizeAnchor>
  <cdr:relSizeAnchor xmlns:cdr="http://schemas.openxmlformats.org/drawingml/2006/chartDrawing">
    <cdr:from>
      <cdr:x>0.25782</cdr:x>
      <cdr:y>0.25984</cdr:y>
    </cdr:from>
    <cdr:to>
      <cdr:x>0.27577</cdr:x>
      <cdr:y>0.29006</cdr:y>
    </cdr:to>
    <cdr:sp macro="" textlink="">
      <cdr:nvSpPr>
        <cdr:cNvPr id="24" name="CasellaDiTesto 23"/>
        <cdr:cNvSpPr txBox="1"/>
      </cdr:nvSpPr>
      <cdr:spPr>
        <a:xfrm xmlns:a="http://schemas.openxmlformats.org/drawingml/2006/main">
          <a:off x="2519592" y="2170559"/>
          <a:ext cx="175419" cy="2524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283</cdr:x>
      <cdr:y>0.64915</cdr:y>
    </cdr:from>
    <cdr:to>
      <cdr:x>0.29461</cdr:x>
      <cdr:y>0.67674</cdr:y>
    </cdr:to>
    <cdr:sp macro="" textlink="">
      <cdr:nvSpPr>
        <cdr:cNvPr id="25" name="CasellaDiTesto 24"/>
        <cdr:cNvSpPr txBox="1"/>
      </cdr:nvSpPr>
      <cdr:spPr>
        <a:xfrm xmlns:a="http://schemas.openxmlformats.org/drawingml/2006/main">
          <a:off x="2552700" y="4705351"/>
          <a:ext cx="104775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26546</cdr:x>
      <cdr:y>0.1207</cdr:y>
    </cdr:from>
    <cdr:to>
      <cdr:x>0.29397</cdr:x>
      <cdr:y>0.15355</cdr:y>
    </cdr:to>
    <cdr:sp macro="" textlink="">
      <cdr:nvSpPr>
        <cdr:cNvPr id="26" name="CasellaDiTesto 25"/>
        <cdr:cNvSpPr txBox="1"/>
      </cdr:nvSpPr>
      <cdr:spPr>
        <a:xfrm xmlns:a="http://schemas.openxmlformats.org/drawingml/2006/main">
          <a:off x="2594216" y="946178"/>
          <a:ext cx="278618" cy="2575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29039</cdr:x>
      <cdr:y>0.54008</cdr:y>
    </cdr:from>
    <cdr:to>
      <cdr:x>0.30517</cdr:x>
      <cdr:y>0.56636</cdr:y>
    </cdr:to>
    <cdr:sp macro="" textlink="">
      <cdr:nvSpPr>
        <cdr:cNvPr id="28" name="CasellaDiTesto 27"/>
        <cdr:cNvSpPr txBox="1"/>
      </cdr:nvSpPr>
      <cdr:spPr>
        <a:xfrm xmlns:a="http://schemas.openxmlformats.org/drawingml/2006/main">
          <a:off x="2619375" y="3914776"/>
          <a:ext cx="133350" cy="1905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9727</cdr:x>
      <cdr:y>0.5806</cdr:y>
    </cdr:from>
    <cdr:to>
      <cdr:x>0.31416</cdr:x>
      <cdr:y>0.61082</cdr:y>
    </cdr:to>
    <cdr:sp macro="" textlink="">
      <cdr:nvSpPr>
        <cdr:cNvPr id="29" name="CasellaDiTesto 28"/>
        <cdr:cNvSpPr txBox="1"/>
      </cdr:nvSpPr>
      <cdr:spPr>
        <a:xfrm xmlns:a="http://schemas.openxmlformats.org/drawingml/2006/main">
          <a:off x="3052360" y="5032488"/>
          <a:ext cx="173426" cy="2619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29989</cdr:x>
      <cdr:y>0.55716</cdr:y>
    </cdr:from>
    <cdr:to>
      <cdr:x>0.31573</cdr:x>
      <cdr:y>0.59001</cdr:y>
    </cdr:to>
    <cdr:sp macro="" textlink="">
      <cdr:nvSpPr>
        <cdr:cNvPr id="30" name="CasellaDiTesto 29"/>
        <cdr:cNvSpPr txBox="1"/>
      </cdr:nvSpPr>
      <cdr:spPr>
        <a:xfrm xmlns:a="http://schemas.openxmlformats.org/drawingml/2006/main">
          <a:off x="2705099" y="4038601"/>
          <a:ext cx="142875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0306</cdr:x>
      <cdr:y>0.38633</cdr:y>
    </cdr:from>
    <cdr:to>
      <cdr:x>0.32841</cdr:x>
      <cdr:y>0.4205</cdr:y>
    </cdr:to>
    <cdr:sp macro="" textlink="">
      <cdr:nvSpPr>
        <cdr:cNvPr id="31" name="CasellaDiTesto 30"/>
        <cdr:cNvSpPr txBox="1"/>
      </cdr:nvSpPr>
      <cdr:spPr>
        <a:xfrm xmlns:a="http://schemas.openxmlformats.org/drawingml/2006/main">
          <a:off x="2733675" y="2800351"/>
          <a:ext cx="228600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1541</cdr:x>
      <cdr:y>0.1746</cdr:y>
    </cdr:from>
    <cdr:to>
      <cdr:x>0.34181</cdr:x>
      <cdr:y>0.20876</cdr:y>
    </cdr:to>
    <cdr:sp macro="" textlink="">
      <cdr:nvSpPr>
        <cdr:cNvPr id="32" name="CasellaDiTesto 31"/>
        <cdr:cNvSpPr txBox="1"/>
      </cdr:nvSpPr>
      <cdr:spPr>
        <a:xfrm xmlns:a="http://schemas.openxmlformats.org/drawingml/2006/main">
          <a:off x="3082379" y="1458511"/>
          <a:ext cx="257997" cy="2853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2459</cdr:x>
      <cdr:y>0.12181</cdr:y>
    </cdr:from>
    <cdr:to>
      <cdr:x>0.34888</cdr:x>
      <cdr:y>0.15072</cdr:y>
    </cdr:to>
    <cdr:sp macro="" textlink="">
      <cdr:nvSpPr>
        <cdr:cNvPr id="33" name="CasellaDiTesto 32"/>
        <cdr:cNvSpPr txBox="1"/>
      </cdr:nvSpPr>
      <cdr:spPr>
        <a:xfrm xmlns:a="http://schemas.openxmlformats.org/drawingml/2006/main">
          <a:off x="3172073" y="954880"/>
          <a:ext cx="237377" cy="2266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33897</cdr:x>
      <cdr:y>0.61367</cdr:y>
    </cdr:from>
    <cdr:to>
      <cdr:x>0.3548</cdr:x>
      <cdr:y>0.63995</cdr:y>
    </cdr:to>
    <cdr:sp macro="" textlink="">
      <cdr:nvSpPr>
        <cdr:cNvPr id="34" name="CasellaDiTesto 33"/>
        <cdr:cNvSpPr txBox="1"/>
      </cdr:nvSpPr>
      <cdr:spPr>
        <a:xfrm xmlns:a="http://schemas.openxmlformats.org/drawingml/2006/main">
          <a:off x="3057525" y="4448177"/>
          <a:ext cx="142875" cy="1905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3453</cdr:x>
      <cdr:y>0.55716</cdr:y>
    </cdr:from>
    <cdr:to>
      <cdr:x>0.37064</cdr:x>
      <cdr:y>0.58476</cdr:y>
    </cdr:to>
    <cdr:sp macro="" textlink="">
      <cdr:nvSpPr>
        <cdr:cNvPr id="35" name="CasellaDiTesto 34"/>
        <cdr:cNvSpPr txBox="1"/>
      </cdr:nvSpPr>
      <cdr:spPr>
        <a:xfrm xmlns:a="http://schemas.openxmlformats.org/drawingml/2006/main">
          <a:off x="3114675" y="4038601"/>
          <a:ext cx="228600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35554</cdr:x>
      <cdr:y>0.55751</cdr:y>
    </cdr:from>
    <cdr:to>
      <cdr:x>0.42417</cdr:x>
      <cdr:y>0.61401</cdr:y>
    </cdr:to>
    <cdr:sp macro="" textlink="">
      <cdr:nvSpPr>
        <cdr:cNvPr id="36" name="CasellaDiTesto 35"/>
        <cdr:cNvSpPr txBox="1"/>
      </cdr:nvSpPr>
      <cdr:spPr>
        <a:xfrm xmlns:a="http://schemas.openxmlformats.org/drawingml/2006/main" rot="16200000">
          <a:off x="3573919" y="4557752"/>
          <a:ext cx="471969" cy="6706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 </a:t>
          </a:r>
        </a:p>
      </cdr:txBody>
    </cdr:sp>
  </cdr:relSizeAnchor>
  <cdr:relSizeAnchor xmlns:cdr="http://schemas.openxmlformats.org/drawingml/2006/chartDrawing">
    <cdr:from>
      <cdr:x>0.37049</cdr:x>
      <cdr:y>0.44812</cdr:y>
    </cdr:from>
    <cdr:to>
      <cdr:x>0.38889</cdr:x>
      <cdr:y>0.47762</cdr:y>
    </cdr:to>
    <cdr:sp macro="" textlink="">
      <cdr:nvSpPr>
        <cdr:cNvPr id="37" name="CasellaDiTesto 36"/>
        <cdr:cNvSpPr txBox="1"/>
      </cdr:nvSpPr>
      <cdr:spPr>
        <a:xfrm xmlns:a="http://schemas.openxmlformats.org/drawingml/2006/main">
          <a:off x="3620663" y="3743330"/>
          <a:ext cx="179813" cy="2464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37427</cdr:x>
      <cdr:y>0.25887</cdr:y>
    </cdr:from>
    <cdr:to>
      <cdr:x>0.40338</cdr:x>
      <cdr:y>0.29304</cdr:y>
    </cdr:to>
    <cdr:sp macro="" textlink="">
      <cdr:nvSpPr>
        <cdr:cNvPr id="38" name="CasellaDiTesto 37"/>
        <cdr:cNvSpPr txBox="1"/>
      </cdr:nvSpPr>
      <cdr:spPr>
        <a:xfrm xmlns:a="http://schemas.openxmlformats.org/drawingml/2006/main">
          <a:off x="3657601" y="2162452"/>
          <a:ext cx="284491" cy="2854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8405</cdr:x>
      <cdr:y>0.1223</cdr:y>
    </cdr:from>
    <cdr:to>
      <cdr:x>0.40622</cdr:x>
      <cdr:y>0.1499</cdr:y>
    </cdr:to>
    <cdr:sp macro="" textlink="">
      <cdr:nvSpPr>
        <cdr:cNvPr id="39" name="CasellaDiTesto 38"/>
        <cdr:cNvSpPr txBox="1"/>
      </cdr:nvSpPr>
      <cdr:spPr>
        <a:xfrm xmlns:a="http://schemas.openxmlformats.org/drawingml/2006/main">
          <a:off x="3753168" y="958758"/>
          <a:ext cx="216659" cy="2163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02</cdr:x>
      <cdr:y>0.51328</cdr:y>
    </cdr:from>
    <cdr:to>
      <cdr:x>0.41784</cdr:x>
      <cdr:y>0.53956</cdr:y>
    </cdr:to>
    <cdr:sp macro="" textlink="">
      <cdr:nvSpPr>
        <cdr:cNvPr id="40" name="CasellaDiTesto 39"/>
        <cdr:cNvSpPr txBox="1"/>
      </cdr:nvSpPr>
      <cdr:spPr>
        <a:xfrm xmlns:a="http://schemas.openxmlformats.org/drawingml/2006/main">
          <a:off x="3928592" y="4287654"/>
          <a:ext cx="154799" cy="2195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40313</cdr:x>
      <cdr:y>0.45308</cdr:y>
    </cdr:from>
    <cdr:to>
      <cdr:x>0.45593</cdr:x>
      <cdr:y>0.49382</cdr:y>
    </cdr:to>
    <cdr:sp macro="" textlink="">
      <cdr:nvSpPr>
        <cdr:cNvPr id="41" name="CasellaDiTesto 40"/>
        <cdr:cNvSpPr txBox="1"/>
      </cdr:nvSpPr>
      <cdr:spPr>
        <a:xfrm xmlns:a="http://schemas.openxmlformats.org/drawingml/2006/main">
          <a:off x="3939688" y="3784759"/>
          <a:ext cx="515996" cy="3403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 d</a:t>
          </a:r>
        </a:p>
      </cdr:txBody>
    </cdr:sp>
  </cdr:relSizeAnchor>
  <cdr:relSizeAnchor xmlns:cdr="http://schemas.openxmlformats.org/drawingml/2006/chartDrawing">
    <cdr:from>
      <cdr:x>0.41933</cdr:x>
      <cdr:y>0.44421</cdr:y>
    </cdr:from>
    <cdr:to>
      <cdr:x>0.45101</cdr:x>
      <cdr:y>0.49283</cdr:y>
    </cdr:to>
    <cdr:sp macro="" textlink="">
      <cdr:nvSpPr>
        <cdr:cNvPr id="43" name="CasellaDiTesto 42"/>
        <cdr:cNvSpPr txBox="1"/>
      </cdr:nvSpPr>
      <cdr:spPr>
        <a:xfrm xmlns:a="http://schemas.openxmlformats.org/drawingml/2006/main" rot="16200000">
          <a:off x="4049726" y="3758973"/>
          <a:ext cx="406143" cy="3095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</a:t>
          </a:r>
        </a:p>
      </cdr:txBody>
    </cdr:sp>
  </cdr:relSizeAnchor>
  <cdr:relSizeAnchor xmlns:cdr="http://schemas.openxmlformats.org/drawingml/2006/chartDrawing">
    <cdr:from>
      <cdr:x>0.42815</cdr:x>
      <cdr:y>0.35147</cdr:y>
    </cdr:from>
    <cdr:to>
      <cdr:x>0.44716</cdr:x>
      <cdr:y>0.3817</cdr:y>
    </cdr:to>
    <cdr:sp macro="" textlink="">
      <cdr:nvSpPr>
        <cdr:cNvPr id="44" name="CasellaDiTesto 43"/>
        <cdr:cNvSpPr txBox="1"/>
      </cdr:nvSpPr>
      <cdr:spPr>
        <a:xfrm xmlns:a="http://schemas.openxmlformats.org/drawingml/2006/main">
          <a:off x="4184186" y="2935988"/>
          <a:ext cx="185778" cy="2525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3481</cdr:x>
      <cdr:y>0.22041</cdr:y>
    </cdr:from>
    <cdr:to>
      <cdr:x>0.45593</cdr:x>
      <cdr:y>0.25721</cdr:y>
    </cdr:to>
    <cdr:sp macro="" textlink="">
      <cdr:nvSpPr>
        <cdr:cNvPr id="45" name="CasellaDiTesto 44"/>
        <cdr:cNvSpPr txBox="1"/>
      </cdr:nvSpPr>
      <cdr:spPr>
        <a:xfrm xmlns:a="http://schemas.openxmlformats.org/drawingml/2006/main">
          <a:off x="4249285" y="1841183"/>
          <a:ext cx="206399" cy="3074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43904</cdr:x>
      <cdr:y>0.12737</cdr:y>
    </cdr:from>
    <cdr:to>
      <cdr:x>0.47599</cdr:x>
      <cdr:y>0.17205</cdr:y>
    </cdr:to>
    <cdr:sp macro="" textlink="">
      <cdr:nvSpPr>
        <cdr:cNvPr id="46" name="CasellaDiTesto 45"/>
        <cdr:cNvSpPr txBox="1"/>
      </cdr:nvSpPr>
      <cdr:spPr>
        <a:xfrm xmlns:a="http://schemas.openxmlformats.org/drawingml/2006/main">
          <a:off x="4290618" y="998425"/>
          <a:ext cx="361099" cy="3502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45926</cdr:x>
      <cdr:y>0.55416</cdr:y>
    </cdr:from>
    <cdr:to>
      <cdr:x>0.47758</cdr:x>
      <cdr:y>0.59511</cdr:y>
    </cdr:to>
    <cdr:sp macro="" textlink="">
      <cdr:nvSpPr>
        <cdr:cNvPr id="47" name="CasellaDiTesto 46"/>
        <cdr:cNvSpPr txBox="1"/>
      </cdr:nvSpPr>
      <cdr:spPr>
        <a:xfrm xmlns:a="http://schemas.openxmlformats.org/drawingml/2006/main">
          <a:off x="4488233" y="4629154"/>
          <a:ext cx="179018" cy="3420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46625</cdr:x>
      <cdr:y>0.47026</cdr:y>
    </cdr:from>
    <cdr:to>
      <cdr:x>0.50638</cdr:x>
      <cdr:y>0.51625</cdr:y>
    </cdr:to>
    <cdr:sp macro="" textlink="">
      <cdr:nvSpPr>
        <cdr:cNvPr id="48" name="CasellaDiTesto 47"/>
        <cdr:cNvSpPr txBox="1"/>
      </cdr:nvSpPr>
      <cdr:spPr>
        <a:xfrm xmlns:a="http://schemas.openxmlformats.org/drawingml/2006/main">
          <a:off x="4556479" y="3928286"/>
          <a:ext cx="392176" cy="3841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 d</a:t>
          </a:r>
        </a:p>
      </cdr:txBody>
    </cdr:sp>
  </cdr:relSizeAnchor>
  <cdr:relSizeAnchor xmlns:cdr="http://schemas.openxmlformats.org/drawingml/2006/chartDrawing">
    <cdr:from>
      <cdr:x>0.48152</cdr:x>
      <cdr:y>0.51767</cdr:y>
    </cdr:from>
    <cdr:to>
      <cdr:x>0.49708</cdr:x>
      <cdr:y>0.55848</cdr:y>
    </cdr:to>
    <cdr:sp macro="" textlink="">
      <cdr:nvSpPr>
        <cdr:cNvPr id="49" name="CasellaDiTesto 48"/>
        <cdr:cNvSpPr txBox="1"/>
      </cdr:nvSpPr>
      <cdr:spPr>
        <a:xfrm xmlns:a="http://schemas.openxmlformats.org/drawingml/2006/main">
          <a:off x="4705727" y="4324354"/>
          <a:ext cx="152024" cy="3408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48761</cdr:x>
      <cdr:y>0.32353</cdr:y>
    </cdr:from>
    <cdr:to>
      <cdr:x>0.5045</cdr:x>
      <cdr:y>0.35507</cdr:y>
    </cdr:to>
    <cdr:sp macro="" textlink="">
      <cdr:nvSpPr>
        <cdr:cNvPr id="50" name="CasellaDiTesto 49"/>
        <cdr:cNvSpPr txBox="1"/>
      </cdr:nvSpPr>
      <cdr:spPr>
        <a:xfrm xmlns:a="http://schemas.openxmlformats.org/drawingml/2006/main">
          <a:off x="4765281" y="2702597"/>
          <a:ext cx="165060" cy="2634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49428</cdr:x>
      <cdr:y>0.20921</cdr:y>
    </cdr:from>
    <cdr:to>
      <cdr:x>0.51329</cdr:x>
      <cdr:y>0.24994</cdr:y>
    </cdr:to>
    <cdr:sp macro="" textlink="">
      <cdr:nvSpPr>
        <cdr:cNvPr id="51" name="CasellaDiTesto 50"/>
        <cdr:cNvSpPr txBox="1"/>
      </cdr:nvSpPr>
      <cdr:spPr>
        <a:xfrm xmlns:a="http://schemas.openxmlformats.org/drawingml/2006/main">
          <a:off x="4830380" y="1747633"/>
          <a:ext cx="185779" cy="3402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0199</cdr:x>
      <cdr:y>0.12332</cdr:y>
    </cdr:from>
    <cdr:to>
      <cdr:x>0.52206</cdr:x>
      <cdr:y>0.15618</cdr:y>
    </cdr:to>
    <cdr:sp macro="" textlink="">
      <cdr:nvSpPr>
        <cdr:cNvPr id="52" name="CasellaDiTesto 51"/>
        <cdr:cNvSpPr txBox="1"/>
      </cdr:nvSpPr>
      <cdr:spPr>
        <a:xfrm xmlns:a="http://schemas.openxmlformats.org/drawingml/2006/main">
          <a:off x="4905741" y="966716"/>
          <a:ext cx="196137" cy="2575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1691</cdr:x>
      <cdr:y>0.63799</cdr:y>
    </cdr:from>
    <cdr:to>
      <cdr:x>0.53697</cdr:x>
      <cdr:y>0.68267</cdr:y>
    </cdr:to>
    <cdr:sp macro="" textlink="">
      <cdr:nvSpPr>
        <cdr:cNvPr id="53" name="CasellaDiTesto 52"/>
        <cdr:cNvSpPr txBox="1"/>
      </cdr:nvSpPr>
      <cdr:spPr>
        <a:xfrm xmlns:a="http://schemas.openxmlformats.org/drawingml/2006/main">
          <a:off x="5307613" y="5529911"/>
          <a:ext cx="205975" cy="387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52423</cdr:x>
      <cdr:y>0.59504</cdr:y>
    </cdr:from>
    <cdr:to>
      <cdr:x>0.55379</cdr:x>
      <cdr:y>0.65155</cdr:y>
    </cdr:to>
    <cdr:sp macro="" textlink="">
      <cdr:nvSpPr>
        <cdr:cNvPr id="54" name="CasellaDiTesto 53"/>
        <cdr:cNvSpPr txBox="1"/>
      </cdr:nvSpPr>
      <cdr:spPr>
        <a:xfrm xmlns:a="http://schemas.openxmlformats.org/drawingml/2006/main" rot="16200000">
          <a:off x="5032805" y="4807205"/>
          <a:ext cx="448907" cy="2883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</a:t>
          </a:r>
        </a:p>
      </cdr:txBody>
    </cdr:sp>
  </cdr:relSizeAnchor>
  <cdr:relSizeAnchor xmlns:cdr="http://schemas.openxmlformats.org/drawingml/2006/chartDrawing">
    <cdr:from>
      <cdr:x>0.53083</cdr:x>
      <cdr:y>0.59795</cdr:y>
    </cdr:from>
    <cdr:to>
      <cdr:x>0.56039</cdr:x>
      <cdr:y>0.6308</cdr:y>
    </cdr:to>
    <cdr:sp macro="" textlink="">
      <cdr:nvSpPr>
        <cdr:cNvPr id="55" name="CasellaDiTesto 54"/>
        <cdr:cNvSpPr txBox="1"/>
      </cdr:nvSpPr>
      <cdr:spPr>
        <a:xfrm xmlns:a="http://schemas.openxmlformats.org/drawingml/2006/main">
          <a:off x="5177471" y="4750042"/>
          <a:ext cx="288316" cy="2609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3866</cdr:x>
      <cdr:y>0.58378</cdr:y>
    </cdr:from>
    <cdr:to>
      <cdr:x>0.57879</cdr:x>
      <cdr:y>0.6508</cdr:y>
    </cdr:to>
    <cdr:sp macro="" textlink="">
      <cdr:nvSpPr>
        <cdr:cNvPr id="57" name="CasellaDiTesto 56"/>
        <cdr:cNvSpPr txBox="1"/>
      </cdr:nvSpPr>
      <cdr:spPr>
        <a:xfrm xmlns:a="http://schemas.openxmlformats.org/drawingml/2006/main" rot="16200000">
          <a:off x="5183385" y="4707943"/>
          <a:ext cx="532397" cy="3914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</a:t>
          </a:r>
        </a:p>
      </cdr:txBody>
    </cdr:sp>
  </cdr:relSizeAnchor>
  <cdr:relSizeAnchor xmlns:cdr="http://schemas.openxmlformats.org/drawingml/2006/chartDrawing">
    <cdr:from>
      <cdr:x>0.5396</cdr:x>
      <cdr:y>0.50066</cdr:y>
    </cdr:from>
    <cdr:to>
      <cdr:x>0.56177</cdr:x>
      <cdr:y>0.54008</cdr:y>
    </cdr:to>
    <cdr:sp macro="" textlink="">
      <cdr:nvSpPr>
        <cdr:cNvPr id="58" name="CasellaDiTesto 57"/>
        <cdr:cNvSpPr txBox="1"/>
      </cdr:nvSpPr>
      <cdr:spPr>
        <a:xfrm xmlns:a="http://schemas.openxmlformats.org/drawingml/2006/main">
          <a:off x="4867275" y="3629027"/>
          <a:ext cx="20002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55227</cdr:x>
      <cdr:y>0.32457</cdr:y>
    </cdr:from>
    <cdr:to>
      <cdr:x>0.56705</cdr:x>
      <cdr:y>0.34954</cdr:y>
    </cdr:to>
    <cdr:sp macro="" textlink="">
      <cdr:nvSpPr>
        <cdr:cNvPr id="59" name="CasellaDiTesto 58"/>
        <cdr:cNvSpPr txBox="1"/>
      </cdr:nvSpPr>
      <cdr:spPr>
        <a:xfrm xmlns:a="http://schemas.openxmlformats.org/drawingml/2006/main">
          <a:off x="4981575" y="2352676"/>
          <a:ext cx="133350" cy="180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56202</cdr:x>
      <cdr:y>0.12444</cdr:y>
    </cdr:from>
    <cdr:to>
      <cdr:x>0.5937</cdr:x>
      <cdr:y>0.15072</cdr:y>
    </cdr:to>
    <cdr:sp macro="" textlink="">
      <cdr:nvSpPr>
        <cdr:cNvPr id="60" name="CasellaDiTesto 59"/>
        <cdr:cNvSpPr txBox="1"/>
      </cdr:nvSpPr>
      <cdr:spPr>
        <a:xfrm xmlns:a="http://schemas.openxmlformats.org/drawingml/2006/main">
          <a:off x="5492386" y="975497"/>
          <a:ext cx="309598" cy="2060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58039</cdr:x>
      <cdr:y>0.52715</cdr:y>
    </cdr:from>
    <cdr:to>
      <cdr:x>0.59307</cdr:x>
      <cdr:y>0.56263</cdr:y>
    </cdr:to>
    <cdr:sp macro="" textlink="">
      <cdr:nvSpPr>
        <cdr:cNvPr id="61" name="CasellaDiTesto 60"/>
        <cdr:cNvSpPr txBox="1"/>
      </cdr:nvSpPr>
      <cdr:spPr>
        <a:xfrm xmlns:a="http://schemas.openxmlformats.org/drawingml/2006/main">
          <a:off x="5959447" y="4569216"/>
          <a:ext cx="130197" cy="3075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57761</cdr:x>
      <cdr:y>0.46255</cdr:y>
    </cdr:from>
    <cdr:to>
      <cdr:x>0.59873</cdr:x>
      <cdr:y>0.49014</cdr:y>
    </cdr:to>
    <cdr:sp macro="" textlink="">
      <cdr:nvSpPr>
        <cdr:cNvPr id="62" name="CasellaDiTesto 61"/>
        <cdr:cNvSpPr txBox="1"/>
      </cdr:nvSpPr>
      <cdr:spPr>
        <a:xfrm xmlns:a="http://schemas.openxmlformats.org/drawingml/2006/main">
          <a:off x="5210175" y="3352801"/>
          <a:ext cx="190500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58606</cdr:x>
      <cdr:y>0.43233</cdr:y>
    </cdr:from>
    <cdr:to>
      <cdr:x>0.6019</cdr:x>
      <cdr:y>0.46518</cdr:y>
    </cdr:to>
    <cdr:sp macro="" textlink="">
      <cdr:nvSpPr>
        <cdr:cNvPr id="63" name="CasellaDiTesto 62"/>
        <cdr:cNvSpPr txBox="1"/>
      </cdr:nvSpPr>
      <cdr:spPr>
        <a:xfrm xmlns:a="http://schemas.openxmlformats.org/drawingml/2006/main">
          <a:off x="5286375" y="3133726"/>
          <a:ext cx="142875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0126</cdr:x>
      <cdr:y>0.53614</cdr:y>
    </cdr:from>
    <cdr:to>
      <cdr:x>0.62027</cdr:x>
      <cdr:y>0.56636</cdr:y>
    </cdr:to>
    <cdr:sp macro="" textlink="">
      <cdr:nvSpPr>
        <cdr:cNvPr id="64" name="CasellaDiTesto 63"/>
        <cdr:cNvSpPr txBox="1"/>
      </cdr:nvSpPr>
      <cdr:spPr>
        <a:xfrm xmlns:a="http://schemas.openxmlformats.org/drawingml/2006/main">
          <a:off x="6173691" y="4647129"/>
          <a:ext cx="195193" cy="2619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60429</cdr:x>
      <cdr:y>0.36602</cdr:y>
    </cdr:from>
    <cdr:to>
      <cdr:x>0.62448</cdr:x>
      <cdr:y>0.40772</cdr:y>
    </cdr:to>
    <cdr:sp macro="" textlink="">
      <cdr:nvSpPr>
        <cdr:cNvPr id="65" name="CasellaDiTesto 64"/>
        <cdr:cNvSpPr txBox="1"/>
      </cdr:nvSpPr>
      <cdr:spPr>
        <a:xfrm xmlns:a="http://schemas.openxmlformats.org/drawingml/2006/main">
          <a:off x="5905501" y="3057529"/>
          <a:ext cx="197297" cy="3483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61246</cdr:x>
      <cdr:y>0.22865</cdr:y>
    </cdr:from>
    <cdr:to>
      <cdr:x>0.6283</cdr:x>
      <cdr:y>0.26281</cdr:y>
    </cdr:to>
    <cdr:sp macro="" textlink="">
      <cdr:nvSpPr>
        <cdr:cNvPr id="66" name="CasellaDiTesto 65"/>
        <cdr:cNvSpPr txBox="1"/>
      </cdr:nvSpPr>
      <cdr:spPr>
        <a:xfrm xmlns:a="http://schemas.openxmlformats.org/drawingml/2006/main">
          <a:off x="5524500" y="1657351"/>
          <a:ext cx="142875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3822</cdr:x>
      <cdr:y>0.56877</cdr:y>
    </cdr:from>
    <cdr:to>
      <cdr:x>0.68891</cdr:x>
      <cdr:y>0.59374</cdr:y>
    </cdr:to>
    <cdr:sp macro="" textlink="">
      <cdr:nvSpPr>
        <cdr:cNvPr id="67" name="CasellaDiTesto 66"/>
        <cdr:cNvSpPr txBox="1"/>
      </cdr:nvSpPr>
      <cdr:spPr>
        <a:xfrm xmlns:a="http://schemas.openxmlformats.org/drawingml/2006/main">
          <a:off x="6553194" y="4929948"/>
          <a:ext cx="520483" cy="2164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d</a:t>
          </a:r>
        </a:p>
      </cdr:txBody>
    </cdr:sp>
  </cdr:relSizeAnchor>
  <cdr:relSizeAnchor xmlns:cdr="http://schemas.openxmlformats.org/drawingml/2006/chartDrawing">
    <cdr:from>
      <cdr:x>0.65145</cdr:x>
      <cdr:y>0.60433</cdr:y>
    </cdr:from>
    <cdr:to>
      <cdr:x>0.67544</cdr:x>
      <cdr:y>0.64513</cdr:y>
    </cdr:to>
    <cdr:sp macro="" textlink="">
      <cdr:nvSpPr>
        <cdr:cNvPr id="68" name="CasellaDiTesto 67"/>
        <cdr:cNvSpPr txBox="1"/>
      </cdr:nvSpPr>
      <cdr:spPr>
        <a:xfrm xmlns:a="http://schemas.openxmlformats.org/drawingml/2006/main">
          <a:off x="6366438" y="5048254"/>
          <a:ext cx="234387" cy="3408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65409</cdr:x>
      <cdr:y>0.47772</cdr:y>
    </cdr:from>
    <cdr:to>
      <cdr:x>0.69949</cdr:x>
      <cdr:y>0.52108</cdr:y>
    </cdr:to>
    <cdr:sp macro="" textlink="">
      <cdr:nvSpPr>
        <cdr:cNvPr id="69" name="CasellaDiTesto 68"/>
        <cdr:cNvSpPr txBox="1"/>
      </cdr:nvSpPr>
      <cdr:spPr>
        <a:xfrm xmlns:a="http://schemas.openxmlformats.org/drawingml/2006/main">
          <a:off x="6716141" y="4140740"/>
          <a:ext cx="466165" cy="3758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  c</a:t>
          </a:r>
        </a:p>
      </cdr:txBody>
    </cdr:sp>
  </cdr:relSizeAnchor>
  <cdr:relSizeAnchor xmlns:cdr="http://schemas.openxmlformats.org/drawingml/2006/chartDrawing">
    <cdr:from>
      <cdr:x>0.672</cdr:x>
      <cdr:y>0.30565</cdr:y>
    </cdr:from>
    <cdr:to>
      <cdr:x>0.70157</cdr:x>
      <cdr:y>0.33194</cdr:y>
    </cdr:to>
    <cdr:sp macro="" textlink="">
      <cdr:nvSpPr>
        <cdr:cNvPr id="70" name="CasellaDiTesto 69"/>
        <cdr:cNvSpPr txBox="1"/>
      </cdr:nvSpPr>
      <cdr:spPr>
        <a:xfrm xmlns:a="http://schemas.openxmlformats.org/drawingml/2006/main">
          <a:off x="6567195" y="2553232"/>
          <a:ext cx="288977" cy="2196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62132</cdr:x>
      <cdr:y>0.12221</cdr:y>
    </cdr:from>
    <cdr:to>
      <cdr:x>0.63821</cdr:x>
      <cdr:y>0.14717</cdr:y>
    </cdr:to>
    <cdr:sp macro="" textlink="">
      <cdr:nvSpPr>
        <cdr:cNvPr id="71" name="CasellaDiTesto 70"/>
        <cdr:cNvSpPr txBox="1"/>
      </cdr:nvSpPr>
      <cdr:spPr>
        <a:xfrm xmlns:a="http://schemas.openxmlformats.org/drawingml/2006/main">
          <a:off x="6071911" y="958014"/>
          <a:ext cx="165060" cy="1956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7947</cdr:x>
      <cdr:y>0.12201</cdr:y>
    </cdr:from>
    <cdr:to>
      <cdr:x>0.70798</cdr:x>
      <cdr:y>0.15355</cdr:y>
    </cdr:to>
    <cdr:sp macro="" textlink="">
      <cdr:nvSpPr>
        <cdr:cNvPr id="72" name="CasellaDiTesto 71"/>
        <cdr:cNvSpPr txBox="1"/>
      </cdr:nvSpPr>
      <cdr:spPr>
        <a:xfrm xmlns:a="http://schemas.openxmlformats.org/drawingml/2006/main">
          <a:off x="6640243" y="956447"/>
          <a:ext cx="278618" cy="2472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69588</cdr:x>
      <cdr:y>0.5795</cdr:y>
    </cdr:from>
    <cdr:to>
      <cdr:x>0.70961</cdr:x>
      <cdr:y>0.60447</cdr:y>
    </cdr:to>
    <cdr:sp macro="" textlink="">
      <cdr:nvSpPr>
        <cdr:cNvPr id="74" name="CasellaDiTesto 73"/>
        <cdr:cNvSpPr txBox="1"/>
      </cdr:nvSpPr>
      <cdr:spPr>
        <a:xfrm xmlns:a="http://schemas.openxmlformats.org/drawingml/2006/main">
          <a:off x="6276975" y="4200526"/>
          <a:ext cx="123825" cy="180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69905</cdr:x>
      <cdr:y>0.54008</cdr:y>
    </cdr:from>
    <cdr:to>
      <cdr:x>0.74551</cdr:x>
      <cdr:y>0.57293</cdr:y>
    </cdr:to>
    <cdr:sp macro="" textlink="">
      <cdr:nvSpPr>
        <cdr:cNvPr id="75" name="CasellaDiTesto 74"/>
        <cdr:cNvSpPr txBox="1"/>
      </cdr:nvSpPr>
      <cdr:spPr>
        <a:xfrm xmlns:a="http://schemas.openxmlformats.org/drawingml/2006/main">
          <a:off x="6305550" y="3914776"/>
          <a:ext cx="419100" cy="2381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d</a:t>
          </a:r>
        </a:p>
      </cdr:txBody>
    </cdr:sp>
  </cdr:relSizeAnchor>
  <cdr:relSizeAnchor xmlns:cdr="http://schemas.openxmlformats.org/drawingml/2006/chartDrawing">
    <cdr:from>
      <cdr:x>0.71383</cdr:x>
      <cdr:y>0.59396</cdr:y>
    </cdr:from>
    <cdr:to>
      <cdr:x>0.73284</cdr:x>
      <cdr:y>0.62286</cdr:y>
    </cdr:to>
    <cdr:sp macro="" textlink="">
      <cdr:nvSpPr>
        <cdr:cNvPr id="76" name="CasellaDiTesto 75"/>
        <cdr:cNvSpPr txBox="1"/>
      </cdr:nvSpPr>
      <cdr:spPr>
        <a:xfrm xmlns:a="http://schemas.openxmlformats.org/drawingml/2006/main">
          <a:off x="6438900" y="4305301"/>
          <a:ext cx="171450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72244</cdr:x>
      <cdr:y>0.45928</cdr:y>
    </cdr:from>
    <cdr:to>
      <cdr:x>0.75834</cdr:x>
      <cdr:y>0.49476</cdr:y>
    </cdr:to>
    <cdr:sp macro="" textlink="">
      <cdr:nvSpPr>
        <cdr:cNvPr id="77" name="CasellaDiTesto 76"/>
        <cdr:cNvSpPr txBox="1"/>
      </cdr:nvSpPr>
      <cdr:spPr>
        <a:xfrm xmlns:a="http://schemas.openxmlformats.org/drawingml/2006/main">
          <a:off x="7418015" y="3980897"/>
          <a:ext cx="368620" cy="3075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2862</cdr:x>
      <cdr:y>0.35742</cdr:y>
    </cdr:from>
    <cdr:to>
      <cdr:x>0.74974</cdr:x>
      <cdr:y>0.38502</cdr:y>
    </cdr:to>
    <cdr:sp macro="" textlink="">
      <cdr:nvSpPr>
        <cdr:cNvPr id="78" name="CasellaDiTesto 77"/>
        <cdr:cNvSpPr txBox="1"/>
      </cdr:nvSpPr>
      <cdr:spPr>
        <a:xfrm xmlns:a="http://schemas.openxmlformats.org/drawingml/2006/main">
          <a:off x="6572250" y="2590801"/>
          <a:ext cx="190500" cy="2000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73853</cdr:x>
      <cdr:y>0.12323</cdr:y>
    </cdr:from>
    <cdr:to>
      <cdr:x>0.76493</cdr:x>
      <cdr:y>0.15345</cdr:y>
    </cdr:to>
    <cdr:sp macro="" textlink="">
      <cdr:nvSpPr>
        <cdr:cNvPr id="79" name="CasellaDiTesto 78"/>
        <cdr:cNvSpPr txBox="1"/>
      </cdr:nvSpPr>
      <cdr:spPr>
        <a:xfrm xmlns:a="http://schemas.openxmlformats.org/drawingml/2006/main">
          <a:off x="7217364" y="965972"/>
          <a:ext cx="257998" cy="2368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529</cdr:x>
      <cdr:y>0.65834</cdr:y>
    </cdr:from>
    <cdr:to>
      <cdr:x>0.77191</cdr:x>
      <cdr:y>0.70039</cdr:y>
    </cdr:to>
    <cdr:sp macro="" textlink="">
      <cdr:nvSpPr>
        <cdr:cNvPr id="80" name="CasellaDiTesto 79"/>
        <cdr:cNvSpPr txBox="1"/>
      </cdr:nvSpPr>
      <cdr:spPr>
        <a:xfrm xmlns:a="http://schemas.openxmlformats.org/drawingml/2006/main">
          <a:off x="6791326" y="4772026"/>
          <a:ext cx="17145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f</a:t>
          </a:r>
        </a:p>
      </cdr:txBody>
    </cdr:sp>
  </cdr:relSizeAnchor>
  <cdr:relSizeAnchor xmlns:cdr="http://schemas.openxmlformats.org/drawingml/2006/chartDrawing">
    <cdr:from>
      <cdr:x>0.75742</cdr:x>
      <cdr:y>0.59658</cdr:y>
    </cdr:from>
    <cdr:to>
      <cdr:x>0.80177</cdr:x>
      <cdr:y>0.63075</cdr:y>
    </cdr:to>
    <cdr:sp macro="" textlink="">
      <cdr:nvSpPr>
        <cdr:cNvPr id="81" name="CasellaDiTesto 80"/>
        <cdr:cNvSpPr txBox="1"/>
      </cdr:nvSpPr>
      <cdr:spPr>
        <a:xfrm xmlns:a="http://schemas.openxmlformats.org/drawingml/2006/main">
          <a:off x="7777110" y="5171008"/>
          <a:ext cx="455383" cy="2961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 e e</a:t>
          </a:r>
        </a:p>
      </cdr:txBody>
    </cdr:sp>
  </cdr:relSizeAnchor>
  <cdr:relSizeAnchor xmlns:cdr="http://schemas.openxmlformats.org/drawingml/2006/chartDrawing">
    <cdr:from>
      <cdr:x>0.77297</cdr:x>
      <cdr:y>0.56899</cdr:y>
    </cdr:from>
    <cdr:to>
      <cdr:x>0.78775</cdr:x>
      <cdr:y>0.59396</cdr:y>
    </cdr:to>
    <cdr:sp macro="" textlink="">
      <cdr:nvSpPr>
        <cdr:cNvPr id="82" name="CasellaDiTesto 81"/>
        <cdr:cNvSpPr txBox="1"/>
      </cdr:nvSpPr>
      <cdr:spPr>
        <a:xfrm xmlns:a="http://schemas.openxmlformats.org/drawingml/2006/main">
          <a:off x="6972300" y="4124326"/>
          <a:ext cx="133350" cy="180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77922</cdr:x>
      <cdr:y>0.5044</cdr:y>
    </cdr:from>
    <cdr:to>
      <cdr:x>0.80058</cdr:x>
      <cdr:y>0.55105</cdr:y>
    </cdr:to>
    <cdr:sp macro="" textlink="">
      <cdr:nvSpPr>
        <cdr:cNvPr id="83" name="CasellaDiTesto 82"/>
        <cdr:cNvSpPr txBox="1"/>
      </cdr:nvSpPr>
      <cdr:spPr>
        <a:xfrm xmlns:a="http://schemas.openxmlformats.org/drawingml/2006/main">
          <a:off x="8001002" y="4371979"/>
          <a:ext cx="219351" cy="4043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78938</cdr:x>
      <cdr:y>0.39028</cdr:y>
    </cdr:from>
    <cdr:to>
      <cdr:x>0.81366</cdr:x>
      <cdr:y>0.4205</cdr:y>
    </cdr:to>
    <cdr:sp macro="" textlink="">
      <cdr:nvSpPr>
        <cdr:cNvPr id="84" name="CasellaDiTesto 83"/>
        <cdr:cNvSpPr txBox="1"/>
      </cdr:nvSpPr>
      <cdr:spPr>
        <a:xfrm xmlns:a="http://schemas.openxmlformats.org/drawingml/2006/main">
          <a:off x="7714315" y="3260176"/>
          <a:ext cx="237280" cy="2524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1415</cdr:x>
      <cdr:y>0.63732</cdr:y>
    </cdr:from>
    <cdr:to>
      <cdr:x>0.82682</cdr:x>
      <cdr:y>0.66229</cdr:y>
    </cdr:to>
    <cdr:sp macro="" textlink="">
      <cdr:nvSpPr>
        <cdr:cNvPr id="85" name="CasellaDiTesto 84"/>
        <cdr:cNvSpPr txBox="1"/>
      </cdr:nvSpPr>
      <cdr:spPr>
        <a:xfrm xmlns:a="http://schemas.openxmlformats.org/drawingml/2006/main">
          <a:off x="7343775" y="4619626"/>
          <a:ext cx="114300" cy="180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81578</cdr:x>
      <cdr:y>0.60982</cdr:y>
    </cdr:from>
    <cdr:to>
      <cdr:x>0.8616</cdr:x>
      <cdr:y>0.6545</cdr:y>
    </cdr:to>
    <cdr:sp macro="" textlink="">
      <cdr:nvSpPr>
        <cdr:cNvPr id="86" name="CasellaDiTesto 85"/>
        <cdr:cNvSpPr txBox="1"/>
      </cdr:nvSpPr>
      <cdr:spPr>
        <a:xfrm xmlns:a="http://schemas.openxmlformats.org/drawingml/2006/main">
          <a:off x="7972313" y="5094103"/>
          <a:ext cx="447788" cy="3732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 e e</a:t>
          </a:r>
        </a:p>
      </cdr:txBody>
    </cdr:sp>
  </cdr:relSizeAnchor>
  <cdr:relSizeAnchor xmlns:cdr="http://schemas.openxmlformats.org/drawingml/2006/chartDrawing">
    <cdr:from>
      <cdr:x>0.83389</cdr:x>
      <cdr:y>0.5439</cdr:y>
    </cdr:from>
    <cdr:to>
      <cdr:x>0.85478</cdr:x>
      <cdr:y>0.57328</cdr:y>
    </cdr:to>
    <cdr:sp macro="" textlink="">
      <cdr:nvSpPr>
        <cdr:cNvPr id="87" name="CasellaDiTesto 86"/>
        <cdr:cNvSpPr txBox="1"/>
      </cdr:nvSpPr>
      <cdr:spPr>
        <a:xfrm xmlns:a="http://schemas.openxmlformats.org/drawingml/2006/main">
          <a:off x="8149303" y="4543429"/>
          <a:ext cx="204123" cy="2454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4209</cdr:x>
      <cdr:y>0.50557</cdr:y>
    </cdr:from>
    <cdr:to>
      <cdr:x>0.86215</cdr:x>
      <cdr:y>0.53973</cdr:y>
    </cdr:to>
    <cdr:sp macro="" textlink="">
      <cdr:nvSpPr>
        <cdr:cNvPr id="88" name="CasellaDiTesto 87"/>
        <cdr:cNvSpPr txBox="1"/>
      </cdr:nvSpPr>
      <cdr:spPr>
        <a:xfrm xmlns:a="http://schemas.openxmlformats.org/drawingml/2006/main">
          <a:off x="8229477" y="4223247"/>
          <a:ext cx="196040" cy="2853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84778</cdr:x>
      <cdr:y>0.33536</cdr:y>
    </cdr:from>
    <cdr:to>
      <cdr:x>0.86784</cdr:x>
      <cdr:y>0.37083</cdr:y>
    </cdr:to>
    <cdr:sp macro="" textlink="">
      <cdr:nvSpPr>
        <cdr:cNvPr id="89" name="CasellaDiTesto 88"/>
        <cdr:cNvSpPr txBox="1"/>
      </cdr:nvSpPr>
      <cdr:spPr>
        <a:xfrm xmlns:a="http://schemas.openxmlformats.org/drawingml/2006/main">
          <a:off x="8285051" y="2801418"/>
          <a:ext cx="196040" cy="2962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85671</cdr:x>
      <cdr:y>0.12484</cdr:y>
    </cdr:from>
    <cdr:to>
      <cdr:x>0.87994</cdr:x>
      <cdr:y>0.15112</cdr:y>
    </cdr:to>
    <cdr:sp macro="" textlink="">
      <cdr:nvSpPr>
        <cdr:cNvPr id="90" name="CasellaDiTesto 89"/>
        <cdr:cNvSpPr txBox="1"/>
      </cdr:nvSpPr>
      <cdr:spPr>
        <a:xfrm xmlns:a="http://schemas.openxmlformats.org/drawingml/2006/main">
          <a:off x="8372341" y="978630"/>
          <a:ext cx="227019" cy="2060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79863</cdr:x>
      <cdr:y>0.12484</cdr:y>
    </cdr:from>
    <cdr:to>
      <cdr:x>0.82398</cdr:x>
      <cdr:y>0.15375</cdr:y>
    </cdr:to>
    <cdr:sp macro="" textlink="">
      <cdr:nvSpPr>
        <cdr:cNvPr id="91" name="CasellaDiTesto 90"/>
        <cdr:cNvSpPr txBox="1"/>
      </cdr:nvSpPr>
      <cdr:spPr>
        <a:xfrm xmlns:a="http://schemas.openxmlformats.org/drawingml/2006/main">
          <a:off x="7804746" y="978630"/>
          <a:ext cx="247736" cy="2266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a</a:t>
          </a:r>
        </a:p>
      </cdr:txBody>
    </cdr:sp>
  </cdr:relSizeAnchor>
  <cdr:relSizeAnchor xmlns:cdr="http://schemas.openxmlformats.org/drawingml/2006/chartDrawing">
    <cdr:from>
      <cdr:x>0.87198</cdr:x>
      <cdr:y>0.59658</cdr:y>
    </cdr:from>
    <cdr:to>
      <cdr:x>0.91316</cdr:x>
      <cdr:y>0.65703</cdr:y>
    </cdr:to>
    <cdr:sp macro="" textlink="">
      <cdr:nvSpPr>
        <cdr:cNvPr id="92" name="CasellaDiTesto 91"/>
        <cdr:cNvSpPr txBox="1"/>
      </cdr:nvSpPr>
      <cdr:spPr>
        <a:xfrm xmlns:a="http://schemas.openxmlformats.org/drawingml/2006/main">
          <a:off x="8521595" y="4983489"/>
          <a:ext cx="402438" cy="5049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 e </a:t>
          </a:r>
        </a:p>
      </cdr:txBody>
    </cdr:sp>
  </cdr:relSizeAnchor>
  <cdr:relSizeAnchor xmlns:cdr="http://schemas.openxmlformats.org/drawingml/2006/chartDrawing">
    <cdr:from>
      <cdr:x>0.88775</cdr:x>
      <cdr:y>0.61962</cdr:y>
    </cdr:from>
    <cdr:to>
      <cdr:x>0.91415</cdr:x>
      <cdr:y>0.65641</cdr:y>
    </cdr:to>
    <cdr:sp macro="" textlink="">
      <cdr:nvSpPr>
        <cdr:cNvPr id="94" name="CasellaDiTesto 93"/>
        <cdr:cNvSpPr txBox="1"/>
      </cdr:nvSpPr>
      <cdr:spPr>
        <a:xfrm xmlns:a="http://schemas.openxmlformats.org/drawingml/2006/main">
          <a:off x="8675658" y="5175943"/>
          <a:ext cx="257998" cy="3073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e</a:t>
          </a:r>
        </a:p>
      </cdr:txBody>
    </cdr:sp>
  </cdr:relSizeAnchor>
  <cdr:relSizeAnchor xmlns:cdr="http://schemas.openxmlformats.org/drawingml/2006/chartDrawing">
    <cdr:from>
      <cdr:x>0.90228</cdr:x>
      <cdr:y>0.51073</cdr:y>
    </cdr:from>
    <cdr:to>
      <cdr:x>0.92657</cdr:x>
      <cdr:y>0.54752</cdr:y>
    </cdr:to>
    <cdr:sp macro="" textlink="">
      <cdr:nvSpPr>
        <cdr:cNvPr id="95" name="CasellaDiTesto 94"/>
        <cdr:cNvSpPr txBox="1"/>
      </cdr:nvSpPr>
      <cdr:spPr>
        <a:xfrm xmlns:a="http://schemas.openxmlformats.org/drawingml/2006/main">
          <a:off x="8817693" y="4266336"/>
          <a:ext cx="237378" cy="3073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</a:t>
          </a:r>
        </a:p>
      </cdr:txBody>
    </cdr:sp>
  </cdr:relSizeAnchor>
  <cdr:relSizeAnchor xmlns:cdr="http://schemas.openxmlformats.org/drawingml/2006/chartDrawing">
    <cdr:from>
      <cdr:x>0.89578</cdr:x>
      <cdr:y>0.465</cdr:y>
    </cdr:from>
    <cdr:to>
      <cdr:x>0.92112</cdr:x>
      <cdr:y>0.49391</cdr:y>
    </cdr:to>
    <cdr:sp macro="" textlink="">
      <cdr:nvSpPr>
        <cdr:cNvPr id="96" name="CasellaDiTesto 95"/>
        <cdr:cNvSpPr txBox="1"/>
      </cdr:nvSpPr>
      <cdr:spPr>
        <a:xfrm xmlns:a="http://schemas.openxmlformats.org/drawingml/2006/main">
          <a:off x="8754164" y="3884347"/>
          <a:ext cx="247639" cy="2414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c</a:t>
          </a:r>
        </a:p>
      </cdr:txBody>
    </cdr:sp>
  </cdr:relSizeAnchor>
  <cdr:relSizeAnchor xmlns:cdr="http://schemas.openxmlformats.org/drawingml/2006/chartDrawing">
    <cdr:from>
      <cdr:x>0.90659</cdr:x>
      <cdr:y>0.26816</cdr:y>
    </cdr:from>
    <cdr:to>
      <cdr:x>0.93088</cdr:x>
      <cdr:y>0.3089</cdr:y>
    </cdr:to>
    <cdr:sp macro="" textlink="">
      <cdr:nvSpPr>
        <cdr:cNvPr id="97" name="CasellaDiTesto 96"/>
        <cdr:cNvSpPr txBox="1"/>
      </cdr:nvSpPr>
      <cdr:spPr>
        <a:xfrm xmlns:a="http://schemas.openxmlformats.org/drawingml/2006/main">
          <a:off x="8859768" y="2240070"/>
          <a:ext cx="237377" cy="3403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b</a:t>
          </a:r>
        </a:p>
      </cdr:txBody>
    </cdr:sp>
  </cdr:relSizeAnchor>
  <cdr:relSizeAnchor xmlns:cdr="http://schemas.openxmlformats.org/drawingml/2006/chartDrawing">
    <cdr:from>
      <cdr:x>0.3613</cdr:x>
      <cdr:y>0.56398</cdr:y>
    </cdr:from>
    <cdr:to>
      <cdr:x>0.42149</cdr:x>
      <cdr:y>0.631</cdr:y>
    </cdr:to>
    <cdr:sp macro="" textlink="">
      <cdr:nvSpPr>
        <cdr:cNvPr id="27" name="CasellaDiTesto 26"/>
        <cdr:cNvSpPr txBox="1"/>
      </cdr:nvSpPr>
      <cdr:spPr>
        <a:xfrm xmlns:a="http://schemas.openxmlformats.org/drawingml/2006/main" rot="16200000">
          <a:off x="3545056" y="4696964"/>
          <a:ext cx="559847" cy="5882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1000"/>
            <a:t>de 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20/08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5903640" y="0"/>
            <a:ext cx="2340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smtClean="0"/>
              <a:t>Magnolol</a:t>
            </a:r>
            <a:r>
              <a:rPr lang="fr-FR" b="1" dirty="0" smtClean="0"/>
              <a:t> </a:t>
            </a:r>
            <a:r>
              <a:rPr lang="fr-FR" b="1" dirty="0" smtClean="0"/>
              <a:t>1</a:t>
            </a:r>
            <a:endParaRPr lang="en-GB" b="1" dirty="0"/>
          </a:p>
        </p:txBody>
      </p:sp>
      <p:graphicFrame>
        <p:nvGraphicFramePr>
          <p:cNvPr id="5" name="Grafico 4">
            <a:extLst>
              <a:ext uri="{FF2B5EF4-FFF2-40B4-BE49-F238E27FC236}">
                <a16:creationId xmlns:lc="http://schemas.openxmlformats.org/drawingml/2006/lockedCanvas" xmlns:a16="http://schemas.microsoft.com/office/drawing/2014/main" xmlns="" xmlns:xdr="http://schemas.openxmlformats.org/drawingml/2006/spreadsheetDrawing" id="{00000000-0008-0000-03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2712076"/>
              </p:ext>
            </p:extLst>
          </p:nvPr>
        </p:nvGraphicFramePr>
        <p:xfrm>
          <a:off x="107503" y="485965"/>
          <a:ext cx="8784977" cy="61113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749513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4</TotalTime>
  <Words>113</Words>
  <Application>Microsoft Office PowerPoint</Application>
  <PresentationFormat>Presentazione su schermo (4:3)</PresentationFormat>
  <Paragraphs>9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fa oufensou</dc:creator>
  <cp:lastModifiedBy>Vanna Delogu</cp:lastModifiedBy>
  <cp:revision>54</cp:revision>
  <dcterms:created xsi:type="dcterms:W3CDTF">2019-06-04T18:45:56Z</dcterms:created>
  <dcterms:modified xsi:type="dcterms:W3CDTF">2019-08-20T09:26:28Z</dcterms:modified>
</cp:coreProperties>
</file>